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28.png" ContentType="image/png"/>
  <Override PartName="/ppt/media/image34.png" ContentType="image/png"/>
  <Override PartName="/ppt/media/image4.png" ContentType="image/png"/>
  <Override PartName="/ppt/media/image16.png" ContentType="image/png"/>
  <Override PartName="/ppt/media/image33.png" ContentType="image/png"/>
  <Override PartName="/ppt/media/image3.png" ContentType="image/png"/>
  <Override PartName="/ppt/media/image15.png" ContentType="image/png"/>
  <Override PartName="/ppt/media/image32.png" ContentType="image/png"/>
  <Override PartName="/ppt/media/image2.png" ContentType="image/png"/>
  <Override PartName="/ppt/media/image14.png" ContentType="image/png"/>
  <Override PartName="/ppt/media/image31.png" ContentType="image/png"/>
  <Override PartName="/ppt/media/image27.png" ContentType="image/png"/>
  <Override PartName="/ppt/media/image64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60.png" ContentType="image/png"/>
  <Override PartName="/ppt/media/image23.png" ContentType="image/png"/>
  <Override PartName="/ppt/media/image58.png" ContentType="image/png"/>
  <Override PartName="/ppt/media/image21.png" ContentType="image/png"/>
  <Override PartName="/ppt/media/image22.png" ContentType="image/png"/>
  <Override PartName="/ppt/media/image59.png" ContentType="image/png"/>
  <Override PartName="/ppt/media/image57.png" ContentType="image/png"/>
  <Override PartName="/ppt/media/image20.png" ContentType="image/png"/>
  <Override PartName="/ppt/media/image61.png" ContentType="image/png"/>
  <Override PartName="/ppt/media/image24.png" ContentType="image/png"/>
  <Override PartName="/ppt/media/image10.png" ContentType="image/png"/>
  <Override PartName="/ppt/media/image47.png" ContentType="image/png"/>
  <Override PartName="/ppt/media/image29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40.png" ContentType="image/png"/>
  <Override PartName="/ppt/media/image41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51.png" ContentType="image/png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6.xml" ContentType="application/vnd.openxmlformats-officedocument.presentationml.slide+xml"/>
  <Override PartName="/ppt/slides/slide45.xml" ContentType="application/vnd.openxmlformats-officedocument.presentationml.slide+xml"/>
  <Override PartName="/ppt/slides/slide39.xml" ContentType="application/vnd.openxmlformats-officedocument.presentationml.slide+xml"/>
  <Override PartName="/ppt/slides/slide38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60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19.xml" ContentType="application/vnd.openxmlformats-officedocument.presentationml.slide+xml"/>
  <Override PartName="/ppt/slides/slide61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69.xml" ContentType="application/vnd.openxmlformats-officedocument.presentationml.slide+xml"/>
  <Override PartName="/ppt/slides/slide32.xml" ContentType="application/vnd.openxmlformats-officedocument.presentationml.slide+xml"/>
  <Override PartName="/ppt/slides/slide70.xml" ContentType="application/vnd.openxmlformats-officedocument.presentationml.slide+xml"/>
  <Override PartName="/ppt/slides/slide28.xml" ContentType="application/vnd.openxmlformats-officedocument.presentationml.slide+xml"/>
  <Override PartName="/ppt/slides/slide68.xml" ContentType="application/vnd.openxmlformats-officedocument.presentationml.slide+xml"/>
  <Override PartName="/ppt/slides/slide31.xml" ContentType="application/vnd.openxmlformats-officedocument.presentationml.slide+xml"/>
  <Override PartName="/ppt/slides/slide67.xml" ContentType="application/vnd.openxmlformats-officedocument.presentationml.slide+xml"/>
  <Override PartName="/ppt/slides/slide30.xml" ContentType="application/vnd.openxmlformats-officedocument.presentationml.slide+xml"/>
  <Override PartName="/ppt/slides/slide27.xml" ContentType="application/vnd.openxmlformats-officedocument.presentationml.slide+xml"/>
  <Override PartName="/ppt/slides/slide64.xml" ContentType="application/vnd.openxmlformats-officedocument.presentationml.slide+xml"/>
  <Override PartName="/ppt/slides/slide66.xml" ContentType="application/vnd.openxmlformats-officedocument.presentationml.slide+xml"/>
  <Override PartName="/ppt/slides/slide29.xml" ContentType="application/vnd.openxmlformats-officedocument.presentationml.slide+xml"/>
  <Override PartName="/ppt/slides/slide26.xml" ContentType="application/vnd.openxmlformats-officedocument.presentationml.slide+xml"/>
  <Override PartName="/ppt/slides/slide63.xml" ContentType="application/vnd.openxmlformats-officedocument.presentationml.slide+xml"/>
  <Override PartName="/ppt/slides/slide65.xml" ContentType="application/vnd.openxmlformats-officedocument.presentationml.slide+xml"/>
  <Override PartName="/ppt/slides/slide25.xml" ContentType="application/vnd.openxmlformats-officedocument.presentationml.slide+xml"/>
  <Override PartName="/ppt/slides/slide62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14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  <Override PartName="/ppt/slides/slide3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15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5.xml" ContentType="application/vnd.openxmlformats-officedocument.presentationml.slide+xml"/>
  <Override PartName="/ppt/slides/slide12.xml" ContentType="application/vnd.openxmlformats-officedocument.presentationml.slide+xml"/>
  <Override PartName="/ppt/slides/slide49.xml" ContentType="application/vnd.openxmlformats-officedocument.presentationml.slide+xml"/>
  <Override PartName="/ppt/slides/_rels/slide34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49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48.xml.rels" ContentType="application/vnd.openxmlformats-package.relationships+xml"/>
  <Override PartName="/ppt/slides/_rels/slide64.xml.rels" ContentType="application/vnd.openxmlformats-package.relationships+xml"/>
  <Override PartName="/ppt/slides/_rels/slide28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37.xml.rels" ContentType="application/vnd.openxmlformats-package.relationships+xml"/>
  <Override PartName="/ppt/slides/_rels/slide22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_rels/slide58.xml.rels" ContentType="application/vnd.openxmlformats-package.relationships+xml"/>
  <Override PartName="/ppt/slides/_rels/slide65.xml.rels" ContentType="application/vnd.openxmlformats-package.relationships+xml"/>
  <Override PartName="/ppt/slides/_rels/slide13.xml.rels" ContentType="application/vnd.openxmlformats-package.relationships+xml"/>
  <Override PartName="/ppt/slides/_rels/slide27.xml.rels" ContentType="application/vnd.openxmlformats-package.relationships+xml"/>
  <Override PartName="/ppt/slides/_rels/slide36.xml.rels" ContentType="application/vnd.openxmlformats-package.relationships+xml"/>
  <Override PartName="/ppt/slides/_rels/slide43.xml.rels" ContentType="application/vnd.openxmlformats-package.relationships+xml"/>
  <Override PartName="/ppt/slides/_rels/slide8.xml.rels" ContentType="application/vnd.openxmlformats-package.relationships+xml"/>
  <Override PartName="/ppt/slides/_rels/slide2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55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42.xml.rels" ContentType="application/vnd.openxmlformats-package.relationships+xml"/>
  <Override PartName="/ppt/slides/_rels/slide7.xml.rels" ContentType="application/vnd.openxmlformats-package.relationships+xml"/>
  <Override PartName="/ppt/slides/_rels/slide61.xml.rels" ContentType="application/vnd.openxmlformats-package.relationships+xml"/>
  <Override PartName="/ppt/slides/_rels/slide57.xml.rels" ContentType="application/vnd.openxmlformats-package.relationships+xml"/>
  <Override PartName="/ppt/slides/_rels/slide54.xml.rels" ContentType="application/vnd.openxmlformats-package.relationships+xml"/>
  <Override PartName="/ppt/slides/_rels/slide63.xml.rels" ContentType="application/vnd.openxmlformats-package.relationships+xml"/>
  <Override PartName="/ppt/slides/_rels/slide70.xml.rels" ContentType="application/vnd.openxmlformats-package.relationships+xml"/>
  <Override PartName="/ppt/slides/_rels/slide69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53.xml.rels" ContentType="application/vnd.openxmlformats-package.relationships+xml"/>
  <Override PartName="/ppt/slides/_rels/slide46.xml.rels" ContentType="application/vnd.openxmlformats-package.relationships+xml"/>
  <Override PartName="/ppt/slides/_rels/slide68.xml.rels" ContentType="application/vnd.openxmlformats-package.relationships+xml"/>
  <Override PartName="/ppt/slides/_rels/slide62.xml.rels" ContentType="application/vnd.openxmlformats-package.relationships+xml"/>
  <Override PartName="/ppt/slides/_rels/slide50.xml.rels" ContentType="application/vnd.openxmlformats-package.relationships+xml"/>
  <Override PartName="/ppt/slides/_rels/slide52.xml.rels" ContentType="application/vnd.openxmlformats-package.relationships+xml"/>
  <Override PartName="/ppt/slides/_rels/slide67.xml.rels" ContentType="application/vnd.openxmlformats-package.relationships+xml"/>
  <Override PartName="/ppt/slides/_rels/slide45.xml.rels" ContentType="application/vnd.openxmlformats-package.relationships+xml"/>
  <Override PartName="/ppt/slides/_rels/slide38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39.xml.rels" ContentType="application/vnd.openxmlformats-package.relationships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5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.xml.rels" ContentType="application/vnd.openxmlformats-package.relationships+xml"/>
  <Override PartName="/ppt/slides/_rels/slide32.xml.rels" ContentType="application/vnd.openxmlformats-package.relationships+xml"/>
  <Override PartName="/ppt/slides/_rels/slide66.xml.rels" ContentType="application/vnd.openxmlformats-package.relationships+xml"/>
  <Override PartName="/ppt/slides/_rels/slide10.xml.rels" ContentType="application/vnd.openxmlformats-package.relationships+xml"/>
  <Override PartName="/ppt/slides/_rels/slide59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slide6.xml" ContentType="application/vnd.openxmlformats-officedocument.presentationml.slide+xml"/>
  <Override PartName="/ppt/slides/slide13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  <p:sldId id="316" r:id="rId63"/>
    <p:sldId id="317" r:id="rId64"/>
    <p:sldId id="318" r:id="rId65"/>
    <p:sldId id="319" r:id="rId66"/>
    <p:sldId id="320" r:id="rId67"/>
    <p:sldId id="321" r:id="rId68"/>
    <p:sldId id="322" r:id="rId69"/>
    <p:sldId id="323" r:id="rId70"/>
    <p:sldId id="324" r:id="rId71"/>
    <p:sldId id="325" r:id="rId7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slide" Target="slides/slide57.xml"/><Relationship Id="rId60" Type="http://schemas.openxmlformats.org/officeDocument/2006/relationships/slide" Target="slides/slide58.xml"/><Relationship Id="rId61" Type="http://schemas.openxmlformats.org/officeDocument/2006/relationships/slide" Target="slides/slide59.xml"/><Relationship Id="rId62" Type="http://schemas.openxmlformats.org/officeDocument/2006/relationships/slide" Target="slides/slide60.xml"/><Relationship Id="rId63" Type="http://schemas.openxmlformats.org/officeDocument/2006/relationships/slide" Target="slides/slide61.xml"/><Relationship Id="rId64" Type="http://schemas.openxmlformats.org/officeDocument/2006/relationships/slide" Target="slides/slide62.xml"/><Relationship Id="rId65" Type="http://schemas.openxmlformats.org/officeDocument/2006/relationships/slide" Target="slides/slide63.xml"/><Relationship Id="rId66" Type="http://schemas.openxmlformats.org/officeDocument/2006/relationships/slide" Target="slides/slide64.xml"/><Relationship Id="rId67" Type="http://schemas.openxmlformats.org/officeDocument/2006/relationships/slide" Target="slides/slide65.xml"/><Relationship Id="rId68" Type="http://schemas.openxmlformats.org/officeDocument/2006/relationships/slide" Target="slides/slide66.xml"/><Relationship Id="rId69" Type="http://schemas.openxmlformats.org/officeDocument/2006/relationships/slide" Target="slides/slide67.xml"/><Relationship Id="rId70" Type="http://schemas.openxmlformats.org/officeDocument/2006/relationships/slide" Target="slides/slide68.xml"/><Relationship Id="rId71" Type="http://schemas.openxmlformats.org/officeDocument/2006/relationships/slide" Target="slides/slide69.xml"/><Relationship Id="rId72" Type="http://schemas.openxmlformats.org/officeDocument/2006/relationships/slide" Target="slides/slide70.xml"/><Relationship Id="rId7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D39E8-E4FB-49E5-B6FD-B7C18A35B9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1D578-CCDC-4616-8DB5-96A799FF10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972D1-8C37-4C54-BA5A-5B7DC40219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986AA1-9634-41FF-BBD8-6C73FCE7D7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029FE-FF60-46A0-BA15-EAD94CE4E2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44C1B-A0E5-4EAB-ACDF-4BD71E5982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05C7B-0670-402D-A5E0-8E17B0F4BF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5471F-0256-4E3C-B37A-E581CB0DC2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B27B9-13AF-46EC-8823-8E2CECE907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46C17-015A-4AA5-A44E-7A565E35DA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34B5AA-E789-4909-9352-BE2926C611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9CE74-4BD6-4CD4-94F7-09068283FC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D06A73-2C89-481B-8075-270547BE3BE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1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slideLayout" Target="../slideLayouts/slideLayout1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slideLayout" Target="../slideLayouts/slideLayout1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slideLayout" Target="../slideLayouts/slideLayout1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slideLayout" Target="../slideLayouts/slideLayout1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slideLayout" Target="../slideLayouts/slideLayout1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slideLayout" Target="../slideLayouts/slideLayout1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slideLayout" Target="../slideLayouts/slideLayout1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slideLayout" Target="../slideLayouts/slideLayout1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image" Target="../media/image56.png"/><Relationship Id="rId2" Type="http://schemas.openxmlformats.org/officeDocument/2006/relationships/slideLayout" Target="../slideLayouts/slideLayout1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slideLayout" Target="../slideLayouts/slideLayout1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slideLayout" Target="../slideLayouts/slideLayout1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image" Target="../media/image59.png"/><Relationship Id="rId2" Type="http://schemas.openxmlformats.org/officeDocument/2006/relationships/slideLayout" Target="../slideLayouts/slideLayout1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slideLayout" Target="../slideLayouts/slideLayout1.xml"/>
</Relationships>
</file>

<file path=ppt/slides/_rels/slide67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slideLayout" Target="../slideLayouts/slideLayout1.xml"/>
</Relationships>
</file>

<file path=ppt/slides/_rels/slide68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slideLayout" Target="../slideLayouts/slideLayout1.xml"/>
</Relationships>
</file>

<file path=ppt/slides/_rels/slide69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0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278160" y="44280"/>
            <a:ext cx="2721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s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835200" y="914400"/>
            <a:ext cx="7767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gnificant Canonical Pathways That Are Involved In Human Pituitary Adenoma Mapping Proteomic Dat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913680" y="1600200"/>
            <a:ext cx="3409920" cy="41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  Acute-phase response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 Citrate cycl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 Methan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4 Glutathion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5 Fatty-acid elongation in mitochondri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6 Pyruvat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7 Protein-ubiquitination pathway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8 Glycolysis/Gluconeogene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9 Propanoat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0 Huntington’s disease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1 Coagulation syste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2 Glucocorticoid-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3 Phenylalanine, tyrosine, and tryptophan biosynthe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4 Pentose and glucuronate interconversion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5 Fructose and mannos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6 14-3-3-mediated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7 Butanoat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8 Stilbene, coumarine, and lignin biosynthe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5410080" y="1600200"/>
            <a:ext cx="3505320" cy="41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19 Ephrin-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0 Calcium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1 PI3K/AKT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2 Valine, leucine, and isoleucine degrad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3 Methionin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4 Lysine degrad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5 Mitochondrial dysfunc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6 Tryptophan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7 Caveolar-mediated endocyto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8 Aryl-hydrocarbon 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9 Phenylalanin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0 TR/RXR activ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1 Regulation of actin-based motility by Rho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2 Antigen-presentation pathway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3 Axonal-guidance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4 IGF-1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5 Amyotrophic lateral sclerosis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6 Cell-cycle G2/M DNA damage checkpoint regul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" descr=""/>
          <p:cNvPicPr/>
          <p:nvPr/>
        </p:nvPicPr>
        <p:blipFill>
          <a:blip r:embed="rId1"/>
          <a:srcRect l="6761" t="5128" r="0" b="1282"/>
          <a:stretch/>
        </p:blipFill>
        <p:spPr>
          <a:xfrm>
            <a:off x="990720" y="304920"/>
            <a:ext cx="7238880" cy="6324480"/>
          </a:xfrm>
          <a:prstGeom prst="rect">
            <a:avLst/>
          </a:prstGeom>
          <a:ln w="0">
            <a:noFill/>
          </a:ln>
        </p:spPr>
      </p:pic>
      <p:sp>
        <p:nvSpPr>
          <p:cNvPr id="101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990360" y="152280"/>
            <a:ext cx="190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lycolysis/Gluconeogene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" descr=""/>
          <p:cNvPicPr/>
          <p:nvPr/>
        </p:nvPicPr>
        <p:blipFill>
          <a:blip r:embed="rId1"/>
          <a:srcRect l="5611" t="11768" r="0" b="2487"/>
          <a:stretch/>
        </p:blipFill>
        <p:spPr>
          <a:xfrm>
            <a:off x="152280" y="1138320"/>
            <a:ext cx="8839440" cy="4805280"/>
          </a:xfrm>
          <a:prstGeom prst="rect">
            <a:avLst/>
          </a:prstGeom>
          <a:ln w="0">
            <a:noFill/>
          </a:ln>
        </p:spPr>
      </p:pic>
      <p:sp>
        <p:nvSpPr>
          <p:cNvPr id="104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230040" y="1066680"/>
            <a:ext cx="1616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ropanoat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7" name=""/>
          <p:cNvGrpSpPr/>
          <p:nvPr/>
        </p:nvGrpSpPr>
        <p:grpSpPr>
          <a:xfrm>
            <a:off x="152280" y="304920"/>
            <a:ext cx="8839440" cy="5715000"/>
            <a:chOff x="152280" y="304920"/>
            <a:chExt cx="8839440" cy="5715000"/>
          </a:xfrm>
        </p:grpSpPr>
        <p:pic>
          <p:nvPicPr>
            <p:cNvPr id="108" name="" descr=""/>
            <p:cNvPicPr/>
            <p:nvPr/>
          </p:nvPicPr>
          <p:blipFill>
            <a:blip r:embed="rId1"/>
            <a:srcRect l="2750" t="5592" r="0" b="1243"/>
            <a:stretch/>
          </p:blipFill>
          <p:spPr>
            <a:xfrm>
              <a:off x="152280" y="533520"/>
              <a:ext cx="8839440" cy="5486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"/>
            <p:cNvSpPr/>
            <p:nvPr/>
          </p:nvSpPr>
          <p:spPr>
            <a:xfrm>
              <a:off x="229680" y="304920"/>
              <a:ext cx="20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untington’s disease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" descr=""/>
          <p:cNvPicPr/>
          <p:nvPr/>
        </p:nvPicPr>
        <p:blipFill>
          <a:blip r:embed="rId1"/>
          <a:srcRect l="6892" t="8435" r="4882" b="1205"/>
          <a:stretch/>
        </p:blipFill>
        <p:spPr>
          <a:xfrm>
            <a:off x="1143000" y="457200"/>
            <a:ext cx="7315200" cy="6095880"/>
          </a:xfrm>
          <a:prstGeom prst="rect">
            <a:avLst/>
          </a:prstGeom>
          <a:ln w="0">
            <a:noFill/>
          </a:ln>
        </p:spPr>
      </p:pic>
      <p:sp>
        <p:nvSpPr>
          <p:cNvPr id="111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1220760" y="228600"/>
            <a:ext cx="1384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agulation syste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" descr=""/>
          <p:cNvPicPr/>
          <p:nvPr/>
        </p:nvPicPr>
        <p:blipFill>
          <a:blip r:embed="rId1"/>
          <a:srcRect l="0" t="0" r="0" b="1912"/>
          <a:stretch/>
        </p:blipFill>
        <p:spPr>
          <a:xfrm>
            <a:off x="152280" y="252360"/>
            <a:ext cx="8763120" cy="6224760"/>
          </a:xfrm>
          <a:prstGeom prst="rect">
            <a:avLst/>
          </a:prstGeom>
          <a:ln w="0">
            <a:noFill/>
          </a:ln>
        </p:spPr>
      </p:pic>
      <p:sp>
        <p:nvSpPr>
          <p:cNvPr id="114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153360" y="152280"/>
            <a:ext cx="221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lucocorticoid-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17" name=""/>
          <p:cNvGrpSpPr/>
          <p:nvPr/>
        </p:nvGrpSpPr>
        <p:grpSpPr>
          <a:xfrm>
            <a:off x="152280" y="152280"/>
            <a:ext cx="8839440" cy="6400440"/>
            <a:chOff x="152280" y="152280"/>
            <a:chExt cx="8839440" cy="6400440"/>
          </a:xfrm>
        </p:grpSpPr>
        <p:pic>
          <p:nvPicPr>
            <p:cNvPr id="118" name="" descr=""/>
            <p:cNvPicPr/>
            <p:nvPr/>
          </p:nvPicPr>
          <p:blipFill>
            <a:blip r:embed="rId1"/>
            <a:srcRect l="3704" t="7582" r="0" b="1452"/>
            <a:stretch/>
          </p:blipFill>
          <p:spPr>
            <a:xfrm>
              <a:off x="152280" y="152280"/>
              <a:ext cx="8839440" cy="6400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" name=""/>
            <p:cNvSpPr/>
            <p:nvPr/>
          </p:nvSpPr>
          <p:spPr>
            <a:xfrm>
              <a:off x="381240" y="314280"/>
              <a:ext cx="339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henylalanine, tyrosine, and tryptophan biosynthes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" descr=""/>
          <p:cNvPicPr/>
          <p:nvPr/>
        </p:nvPicPr>
        <p:blipFill>
          <a:blip r:embed="rId1"/>
          <a:srcRect l="3737" t="6163" r="0" b="1386"/>
          <a:stretch/>
        </p:blipFill>
        <p:spPr>
          <a:xfrm>
            <a:off x="380880" y="179280"/>
            <a:ext cx="8382240" cy="6434280"/>
          </a:xfrm>
          <a:prstGeom prst="rect">
            <a:avLst/>
          </a:prstGeom>
          <a:ln w="0">
            <a:noFill/>
          </a:ln>
        </p:spPr>
      </p:pic>
      <p:sp>
        <p:nvSpPr>
          <p:cNvPr id="121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458280" y="152280"/>
            <a:ext cx="274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entose and glucuronate interconversion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" descr=""/>
          <p:cNvPicPr/>
          <p:nvPr/>
        </p:nvPicPr>
        <p:blipFill>
          <a:blip r:embed="rId1"/>
          <a:srcRect l="4826" t="5391" r="0" b="1628"/>
          <a:stretch/>
        </p:blipFill>
        <p:spPr>
          <a:xfrm>
            <a:off x="152280" y="210960"/>
            <a:ext cx="8839440" cy="6399360"/>
          </a:xfrm>
          <a:prstGeom prst="rect">
            <a:avLst/>
          </a:prstGeom>
          <a:ln w="0">
            <a:noFill/>
          </a:ln>
        </p:spPr>
      </p:pic>
      <p:sp>
        <p:nvSpPr>
          <p:cNvPr id="124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305280" y="152280"/>
            <a:ext cx="23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ructose and mannos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27" name=""/>
          <p:cNvGrpSpPr/>
          <p:nvPr/>
        </p:nvGrpSpPr>
        <p:grpSpPr>
          <a:xfrm>
            <a:off x="915120" y="152280"/>
            <a:ext cx="7619400" cy="6477120"/>
            <a:chOff x="915120" y="152280"/>
            <a:chExt cx="7619400" cy="6477120"/>
          </a:xfrm>
        </p:grpSpPr>
        <p:pic>
          <p:nvPicPr>
            <p:cNvPr id="128" name="" descr=""/>
            <p:cNvPicPr/>
            <p:nvPr/>
          </p:nvPicPr>
          <p:blipFill>
            <a:blip r:embed="rId1"/>
            <a:srcRect l="12559" t="10256" r="0" b="2564"/>
            <a:stretch/>
          </p:blipFill>
          <p:spPr>
            <a:xfrm>
              <a:off x="990720" y="380880"/>
              <a:ext cx="7543800" cy="624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9" name=""/>
            <p:cNvSpPr/>
            <p:nvPr/>
          </p:nvSpPr>
          <p:spPr>
            <a:xfrm>
              <a:off x="915120" y="152280"/>
              <a:ext cx="173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4-3-3-mediated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" descr=""/>
          <p:cNvPicPr/>
          <p:nvPr/>
        </p:nvPicPr>
        <p:blipFill>
          <a:blip r:embed="rId1"/>
          <a:srcRect l="2061" t="7143" r="0" b="1190"/>
          <a:stretch/>
        </p:blipFill>
        <p:spPr>
          <a:xfrm>
            <a:off x="228600" y="152280"/>
            <a:ext cx="8686800" cy="6400800"/>
          </a:xfrm>
          <a:prstGeom prst="rect">
            <a:avLst/>
          </a:prstGeom>
          <a:ln w="0">
            <a:noFill/>
          </a:ln>
        </p:spPr>
      </p:pic>
      <p:sp>
        <p:nvSpPr>
          <p:cNvPr id="131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382320" y="304920"/>
            <a:ext cx="154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utanoat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"/>
          <p:cNvGrpSpPr/>
          <p:nvPr/>
        </p:nvGrpSpPr>
        <p:grpSpPr>
          <a:xfrm>
            <a:off x="838080" y="1295280"/>
            <a:ext cx="7239240" cy="3065760"/>
            <a:chOff x="838080" y="1295280"/>
            <a:chExt cx="7239240" cy="3065760"/>
          </a:xfrm>
        </p:grpSpPr>
        <p:sp>
          <p:nvSpPr>
            <p:cNvPr id="46" name=""/>
            <p:cNvSpPr/>
            <p:nvPr/>
          </p:nvSpPr>
          <p:spPr>
            <a:xfrm>
              <a:off x="1295280" y="1981080"/>
              <a:ext cx="228600" cy="304920"/>
            </a:xfrm>
            <a:prstGeom prst="diamond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124080" y="1981080"/>
              <a:ext cx="457200" cy="266760"/>
            </a:xfrm>
            <a:prstGeom prst="flowChartDecision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648320" y="1981080"/>
              <a:ext cx="228600" cy="228600"/>
            </a:xfrm>
            <a:prstGeom prst="flowChartMerge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6095880" y="1981080"/>
              <a:ext cx="228600" cy="228600"/>
            </a:xfrm>
            <a:prstGeom prst="flowChartExtract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295280" y="2514600"/>
              <a:ext cx="343080" cy="22860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0800000">
              <a:off x="4648320" y="2437920"/>
              <a:ext cx="342720" cy="228600"/>
            </a:xfrm>
            <a:prstGeom prst="flowChartManualOperation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095880" y="2362320"/>
              <a:ext cx="228600" cy="34272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295280" y="3048120"/>
              <a:ext cx="343080" cy="228600"/>
            </a:xfrm>
            <a:prstGeom prst="ellipse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200400" y="2438280"/>
              <a:ext cx="380880" cy="30492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914400" y="1600200"/>
              <a:ext cx="441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 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(ii)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he various shapes of nodes denote the different functions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600200" y="1981080"/>
              <a:ext cx="71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nzym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579480" y="1981080"/>
              <a:ext cx="84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eptidas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029200" y="1981080"/>
              <a:ext cx="62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kinas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6550200" y="1981080"/>
              <a:ext cx="105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hosphatas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597320" y="2438280"/>
              <a:ext cx="159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ytokine or regulator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656520" y="2438280"/>
              <a:ext cx="886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etabolit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028840" y="2438280"/>
              <a:ext cx="919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ransporter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627240" y="2438280"/>
              <a:ext cx="973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on channel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676520" y="3048120"/>
              <a:ext cx="60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other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219320" y="3429000"/>
              <a:ext cx="510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iii) A duplicated shape means this node contains multiple components.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219320" y="3733920"/>
              <a:ext cx="685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iv) A arrow (               ) denotes the pathway direction.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133720" y="388620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222560" y="4114800"/>
              <a:ext cx="4263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v) A line with a small circle (                         ) denotes a biological result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971800" y="4267080"/>
              <a:ext cx="60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581280" y="4191120"/>
              <a:ext cx="152640" cy="145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838080" y="1295280"/>
              <a:ext cx="304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ote: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(i) A gray label denotes an identified protein.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" descr=""/>
          <p:cNvPicPr/>
          <p:nvPr/>
        </p:nvPicPr>
        <p:blipFill>
          <a:blip r:embed="rId1"/>
          <a:srcRect l="6250" t="13908" r="0" b="2640"/>
          <a:stretch/>
        </p:blipFill>
        <p:spPr>
          <a:xfrm>
            <a:off x="152280" y="914400"/>
            <a:ext cx="8686800" cy="5029200"/>
          </a:xfrm>
          <a:prstGeom prst="rect">
            <a:avLst/>
          </a:prstGeom>
          <a:ln w="0">
            <a:noFill/>
          </a:ln>
        </p:spPr>
      </p:pic>
      <p:sp>
        <p:nvSpPr>
          <p:cNvPr id="134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305280" y="762120"/>
            <a:ext cx="286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tilbene, coumarine, and lignin biosynthe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" descr=""/>
          <p:cNvPicPr/>
          <p:nvPr/>
        </p:nvPicPr>
        <p:blipFill>
          <a:blip r:embed="rId1"/>
          <a:srcRect l="7272" t="8483" r="0" b="1843"/>
          <a:stretch/>
        </p:blipFill>
        <p:spPr>
          <a:xfrm>
            <a:off x="152280" y="152280"/>
            <a:ext cx="8839440" cy="6469200"/>
          </a:xfrm>
          <a:prstGeom prst="rect">
            <a:avLst/>
          </a:prstGeom>
          <a:ln w="0">
            <a:noFill/>
          </a:ln>
        </p:spPr>
      </p:pic>
      <p:sp>
        <p:nvSpPr>
          <p:cNvPr id="137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230400" y="152280"/>
            <a:ext cx="172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phrin-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" descr=""/>
          <p:cNvPicPr/>
          <p:nvPr/>
        </p:nvPicPr>
        <p:blipFill>
          <a:blip r:embed="rId1"/>
          <a:srcRect l="3576" t="10080" r="5198" b="2556"/>
          <a:stretch/>
        </p:blipFill>
        <p:spPr>
          <a:xfrm>
            <a:off x="152280" y="762120"/>
            <a:ext cx="8763120" cy="4647960"/>
          </a:xfrm>
          <a:prstGeom prst="rect">
            <a:avLst/>
          </a:prstGeom>
          <a:ln w="0">
            <a:noFill/>
          </a:ln>
        </p:spPr>
      </p:pic>
      <p:sp>
        <p:nvSpPr>
          <p:cNvPr id="140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229680" y="457200"/>
            <a:ext cx="1264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alcium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" descr=""/>
          <p:cNvPicPr/>
          <p:nvPr/>
        </p:nvPicPr>
        <p:blipFill>
          <a:blip r:embed="rId1"/>
          <a:srcRect l="16364" t="12666" r="1819" b="2133"/>
          <a:stretch/>
        </p:blipFill>
        <p:spPr>
          <a:xfrm>
            <a:off x="533520" y="380880"/>
            <a:ext cx="8229600" cy="6096240"/>
          </a:xfrm>
          <a:prstGeom prst="rect">
            <a:avLst/>
          </a:prstGeom>
          <a:ln w="0">
            <a:noFill/>
          </a:ln>
        </p:spPr>
      </p:pic>
      <p:sp>
        <p:nvSpPr>
          <p:cNvPr id="143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383040" y="152280"/>
            <a:ext cx="134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I3K/AKT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" descr=""/>
          <p:cNvPicPr/>
          <p:nvPr/>
        </p:nvPicPr>
        <p:blipFill>
          <a:blip r:embed="rId1"/>
          <a:srcRect l="9092" t="6097" r="0" b="1218"/>
          <a:stretch/>
        </p:blipFill>
        <p:spPr>
          <a:xfrm>
            <a:off x="685800" y="304920"/>
            <a:ext cx="7848720" cy="6324480"/>
          </a:xfrm>
          <a:prstGeom prst="rect">
            <a:avLst/>
          </a:prstGeom>
          <a:ln w="0">
            <a:noFill/>
          </a:ln>
        </p:spPr>
      </p:pic>
      <p:sp>
        <p:nvSpPr>
          <p:cNvPr id="146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609480" y="152280"/>
            <a:ext cx="276840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Valine, leucine, and isoleucine degrad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9" name=""/>
          <p:cNvGrpSpPr/>
          <p:nvPr/>
        </p:nvGrpSpPr>
        <p:grpSpPr>
          <a:xfrm>
            <a:off x="228600" y="228600"/>
            <a:ext cx="8763120" cy="6370560"/>
            <a:chOff x="228600" y="228600"/>
            <a:chExt cx="8763120" cy="6370560"/>
          </a:xfrm>
        </p:grpSpPr>
        <p:pic>
          <p:nvPicPr>
            <p:cNvPr id="150" name="" descr=""/>
            <p:cNvPicPr/>
            <p:nvPr/>
          </p:nvPicPr>
          <p:blipFill>
            <a:blip r:embed="rId1"/>
            <a:srcRect l="7767" t="10743" r="0" b="2115"/>
            <a:stretch/>
          </p:blipFill>
          <p:spPr>
            <a:xfrm>
              <a:off x="228600" y="235080"/>
              <a:ext cx="8763120" cy="6364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1" name=""/>
            <p:cNvSpPr/>
            <p:nvPr/>
          </p:nvSpPr>
          <p:spPr>
            <a:xfrm>
              <a:off x="230040" y="228600"/>
              <a:ext cx="158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thionine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" descr=""/>
          <p:cNvPicPr/>
          <p:nvPr/>
        </p:nvPicPr>
        <p:blipFill>
          <a:blip r:embed="rId1"/>
          <a:srcRect l="4853" t="8296" r="0" b="1654"/>
          <a:stretch/>
        </p:blipFill>
        <p:spPr>
          <a:xfrm>
            <a:off x="152280" y="230040"/>
            <a:ext cx="8763120" cy="6440760"/>
          </a:xfrm>
          <a:prstGeom prst="rect">
            <a:avLst/>
          </a:prstGeom>
          <a:ln w="0">
            <a:noFill/>
          </a:ln>
        </p:spPr>
      </p:pic>
      <p:sp>
        <p:nvSpPr>
          <p:cNvPr id="153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306000" y="228600"/>
            <a:ext cx="134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ysine degrad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56" name=""/>
          <p:cNvGrpSpPr/>
          <p:nvPr/>
        </p:nvGrpSpPr>
        <p:grpSpPr>
          <a:xfrm>
            <a:off x="152280" y="152280"/>
            <a:ext cx="8763120" cy="6477120"/>
            <a:chOff x="152280" y="152280"/>
            <a:chExt cx="8763120" cy="6477120"/>
          </a:xfrm>
        </p:grpSpPr>
        <p:pic>
          <p:nvPicPr>
            <p:cNvPr id="157" name="" descr=""/>
            <p:cNvPicPr/>
            <p:nvPr/>
          </p:nvPicPr>
          <p:blipFill>
            <a:blip r:embed="rId1"/>
            <a:srcRect l="4386" t="8640" r="0" b="1261"/>
            <a:stretch/>
          </p:blipFill>
          <p:spPr>
            <a:xfrm>
              <a:off x="152280" y="455760"/>
              <a:ext cx="8763120" cy="617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8" name=""/>
            <p:cNvSpPr/>
            <p:nvPr/>
          </p:nvSpPr>
          <p:spPr>
            <a:xfrm>
              <a:off x="154440" y="152280"/>
              <a:ext cx="176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itochondrial dysfunc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60" name=""/>
          <p:cNvGrpSpPr/>
          <p:nvPr/>
        </p:nvGrpSpPr>
        <p:grpSpPr>
          <a:xfrm>
            <a:off x="380880" y="133200"/>
            <a:ext cx="8305920" cy="6467760"/>
            <a:chOff x="380880" y="133200"/>
            <a:chExt cx="8305920" cy="6467760"/>
          </a:xfrm>
        </p:grpSpPr>
        <p:pic>
          <p:nvPicPr>
            <p:cNvPr id="161" name="" descr=""/>
            <p:cNvPicPr/>
            <p:nvPr/>
          </p:nvPicPr>
          <p:blipFill>
            <a:blip r:embed="rId1"/>
            <a:srcRect l="5377" t="8182" r="0" b="1826"/>
            <a:stretch/>
          </p:blipFill>
          <p:spPr>
            <a:xfrm>
              <a:off x="380880" y="133200"/>
              <a:ext cx="8305920" cy="6467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2" name=""/>
            <p:cNvSpPr/>
            <p:nvPr/>
          </p:nvSpPr>
          <p:spPr>
            <a:xfrm>
              <a:off x="458640" y="152280"/>
              <a:ext cx="161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ryptophan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64" name=""/>
          <p:cNvGrpSpPr/>
          <p:nvPr/>
        </p:nvGrpSpPr>
        <p:grpSpPr>
          <a:xfrm>
            <a:off x="685800" y="152280"/>
            <a:ext cx="7467480" cy="6494760"/>
            <a:chOff x="685800" y="152280"/>
            <a:chExt cx="7467480" cy="6494760"/>
          </a:xfrm>
        </p:grpSpPr>
        <p:pic>
          <p:nvPicPr>
            <p:cNvPr id="165" name="" descr=""/>
            <p:cNvPicPr/>
            <p:nvPr/>
          </p:nvPicPr>
          <p:blipFill>
            <a:blip r:embed="rId1"/>
            <a:srcRect l="0" t="10975" r="0" b="2440"/>
            <a:stretch/>
          </p:blipFill>
          <p:spPr>
            <a:xfrm>
              <a:off x="685800" y="334800"/>
              <a:ext cx="7467480" cy="6312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6" name=""/>
            <p:cNvSpPr/>
            <p:nvPr/>
          </p:nvSpPr>
          <p:spPr>
            <a:xfrm>
              <a:off x="686520" y="152280"/>
              <a:ext cx="2087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aveolar-mediated endocytos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3" name=""/>
          <p:cNvGrpSpPr/>
          <p:nvPr/>
        </p:nvGrpSpPr>
        <p:grpSpPr>
          <a:xfrm>
            <a:off x="228600" y="152280"/>
            <a:ext cx="8686800" cy="6400800"/>
            <a:chOff x="228600" y="152280"/>
            <a:chExt cx="8686800" cy="6400800"/>
          </a:xfrm>
        </p:grpSpPr>
        <p:pic>
          <p:nvPicPr>
            <p:cNvPr id="74" name="" descr=""/>
            <p:cNvPicPr/>
            <p:nvPr/>
          </p:nvPicPr>
          <p:blipFill>
            <a:blip r:embed="rId1"/>
            <a:srcRect l="5263" t="4678" r="0" b="584"/>
            <a:stretch/>
          </p:blipFill>
          <p:spPr>
            <a:xfrm>
              <a:off x="228600" y="152280"/>
              <a:ext cx="8686800" cy="6400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"/>
            <p:cNvSpPr/>
            <p:nvPr/>
          </p:nvSpPr>
          <p:spPr>
            <a:xfrm>
              <a:off x="229680" y="228600"/>
              <a:ext cx="212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cute-phase response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68" name=""/>
          <p:cNvGrpSpPr/>
          <p:nvPr/>
        </p:nvGrpSpPr>
        <p:grpSpPr>
          <a:xfrm>
            <a:off x="152280" y="228600"/>
            <a:ext cx="8839440" cy="6019920"/>
            <a:chOff x="152280" y="228600"/>
            <a:chExt cx="8839440" cy="6019920"/>
          </a:xfrm>
        </p:grpSpPr>
        <p:pic>
          <p:nvPicPr>
            <p:cNvPr id="169" name="" descr=""/>
            <p:cNvPicPr/>
            <p:nvPr/>
          </p:nvPicPr>
          <p:blipFill>
            <a:blip r:embed="rId1"/>
            <a:srcRect l="1761" t="5661" r="0" b="1888"/>
            <a:stretch/>
          </p:blipFill>
          <p:spPr>
            <a:xfrm>
              <a:off x="152280" y="533520"/>
              <a:ext cx="8839440" cy="5715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0" name=""/>
            <p:cNvSpPr/>
            <p:nvPr/>
          </p:nvSpPr>
          <p:spPr>
            <a:xfrm>
              <a:off x="230760" y="228600"/>
              <a:ext cx="237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ryl-hydrocarbon receptor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72" name=""/>
          <p:cNvGrpSpPr/>
          <p:nvPr/>
        </p:nvGrpSpPr>
        <p:grpSpPr>
          <a:xfrm>
            <a:off x="152280" y="152280"/>
            <a:ext cx="8839440" cy="6400800"/>
            <a:chOff x="152280" y="152280"/>
            <a:chExt cx="8839440" cy="6400800"/>
          </a:xfrm>
        </p:grpSpPr>
        <p:pic>
          <p:nvPicPr>
            <p:cNvPr id="173" name="" descr=""/>
            <p:cNvPicPr/>
            <p:nvPr/>
          </p:nvPicPr>
          <p:blipFill>
            <a:blip r:embed="rId1"/>
            <a:srcRect l="4464" t="9015" r="0" b="2347"/>
            <a:stretch/>
          </p:blipFill>
          <p:spPr>
            <a:xfrm>
              <a:off x="152280" y="380880"/>
              <a:ext cx="8839440" cy="617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4" name=""/>
            <p:cNvSpPr/>
            <p:nvPr/>
          </p:nvSpPr>
          <p:spPr>
            <a:xfrm>
              <a:off x="305640" y="152280"/>
              <a:ext cx="177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henylalanine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3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76" name=""/>
          <p:cNvGrpSpPr/>
          <p:nvPr/>
        </p:nvGrpSpPr>
        <p:grpSpPr>
          <a:xfrm>
            <a:off x="152280" y="228600"/>
            <a:ext cx="8763120" cy="6095880"/>
            <a:chOff x="152280" y="228600"/>
            <a:chExt cx="8763120" cy="6095880"/>
          </a:xfrm>
        </p:grpSpPr>
        <p:pic>
          <p:nvPicPr>
            <p:cNvPr id="177" name="" descr=""/>
            <p:cNvPicPr/>
            <p:nvPr/>
          </p:nvPicPr>
          <p:blipFill>
            <a:blip r:embed="rId1"/>
            <a:srcRect l="3541" t="8299" r="1770" b="2075"/>
            <a:stretch/>
          </p:blipFill>
          <p:spPr>
            <a:xfrm>
              <a:off x="152280" y="533520"/>
              <a:ext cx="8763120" cy="5790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8" name=""/>
            <p:cNvSpPr/>
            <p:nvPr/>
          </p:nvSpPr>
          <p:spPr>
            <a:xfrm>
              <a:off x="230760" y="228600"/>
              <a:ext cx="127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R/RXR activ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3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80" name=""/>
          <p:cNvGrpSpPr/>
          <p:nvPr/>
        </p:nvGrpSpPr>
        <p:grpSpPr>
          <a:xfrm>
            <a:off x="457200" y="152280"/>
            <a:ext cx="8305920" cy="6477120"/>
            <a:chOff x="457200" y="152280"/>
            <a:chExt cx="8305920" cy="6477120"/>
          </a:xfrm>
        </p:grpSpPr>
        <p:pic>
          <p:nvPicPr>
            <p:cNvPr id="181" name="" descr=""/>
            <p:cNvPicPr/>
            <p:nvPr/>
          </p:nvPicPr>
          <p:blipFill>
            <a:blip r:embed="rId1"/>
            <a:srcRect l="10344" t="13335" r="1148" b="1793"/>
            <a:stretch/>
          </p:blipFill>
          <p:spPr>
            <a:xfrm>
              <a:off x="457200" y="457200"/>
              <a:ext cx="8305920" cy="617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2" name=""/>
            <p:cNvSpPr/>
            <p:nvPr/>
          </p:nvSpPr>
          <p:spPr>
            <a:xfrm>
              <a:off x="534960" y="152280"/>
              <a:ext cx="268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gulation of actin-based motility by Rh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3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84" name=""/>
          <p:cNvGrpSpPr/>
          <p:nvPr/>
        </p:nvGrpSpPr>
        <p:grpSpPr>
          <a:xfrm>
            <a:off x="228600" y="152280"/>
            <a:ext cx="8686800" cy="6477120"/>
            <a:chOff x="228600" y="152280"/>
            <a:chExt cx="8686800" cy="6477120"/>
          </a:xfrm>
        </p:grpSpPr>
        <p:pic>
          <p:nvPicPr>
            <p:cNvPr id="185" name="" descr=""/>
            <p:cNvPicPr/>
            <p:nvPr/>
          </p:nvPicPr>
          <p:blipFill>
            <a:blip r:embed="rId1"/>
            <a:srcRect l="10092" t="13365" r="0" b="3511"/>
            <a:stretch/>
          </p:blipFill>
          <p:spPr>
            <a:xfrm>
              <a:off x="228600" y="336600"/>
              <a:ext cx="8686800" cy="629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6" name=""/>
            <p:cNvSpPr/>
            <p:nvPr/>
          </p:nvSpPr>
          <p:spPr>
            <a:xfrm>
              <a:off x="230040" y="152280"/>
              <a:ext cx="199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ntigen-presentation pathwa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3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88" name=""/>
          <p:cNvGrpSpPr/>
          <p:nvPr/>
        </p:nvGrpSpPr>
        <p:grpSpPr>
          <a:xfrm>
            <a:off x="152280" y="914400"/>
            <a:ext cx="8839440" cy="5029200"/>
            <a:chOff x="152280" y="914400"/>
            <a:chExt cx="8839440" cy="5029200"/>
          </a:xfrm>
        </p:grpSpPr>
        <p:pic>
          <p:nvPicPr>
            <p:cNvPr id="189" name="" descr=""/>
            <p:cNvPicPr/>
            <p:nvPr/>
          </p:nvPicPr>
          <p:blipFill>
            <a:blip r:embed="rId1"/>
            <a:srcRect l="1755" t="8887" r="0" b="2221"/>
            <a:stretch/>
          </p:blipFill>
          <p:spPr>
            <a:xfrm>
              <a:off x="152280" y="990720"/>
              <a:ext cx="8839440" cy="4952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0" name=""/>
            <p:cNvSpPr/>
            <p:nvPr/>
          </p:nvSpPr>
          <p:spPr>
            <a:xfrm>
              <a:off x="229680" y="914400"/>
              <a:ext cx="179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xonal-guidance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3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92" name=""/>
          <p:cNvGrpSpPr/>
          <p:nvPr/>
        </p:nvGrpSpPr>
        <p:grpSpPr>
          <a:xfrm>
            <a:off x="228600" y="152280"/>
            <a:ext cx="8763120" cy="6449760"/>
            <a:chOff x="228600" y="152280"/>
            <a:chExt cx="8763120" cy="6449760"/>
          </a:xfrm>
        </p:grpSpPr>
        <p:pic>
          <p:nvPicPr>
            <p:cNvPr id="193" name="" descr=""/>
            <p:cNvPicPr/>
            <p:nvPr/>
          </p:nvPicPr>
          <p:blipFill>
            <a:blip r:embed="rId1"/>
            <a:srcRect l="10309" t="12001" r="2062" b="4003"/>
            <a:stretch/>
          </p:blipFill>
          <p:spPr>
            <a:xfrm>
              <a:off x="228600" y="239760"/>
              <a:ext cx="8763120" cy="6362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4" name=""/>
            <p:cNvSpPr/>
            <p:nvPr/>
          </p:nvSpPr>
          <p:spPr>
            <a:xfrm>
              <a:off x="229680" y="152280"/>
              <a:ext cx="109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GF-1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" descr=""/>
          <p:cNvPicPr/>
          <p:nvPr/>
        </p:nvPicPr>
        <p:blipFill>
          <a:blip r:embed="rId1"/>
          <a:srcRect l="4465" t="9736" r="0" b="2636"/>
          <a:stretch/>
        </p:blipFill>
        <p:spPr>
          <a:xfrm>
            <a:off x="228600" y="828720"/>
            <a:ext cx="8763120" cy="5267160"/>
          </a:xfrm>
          <a:prstGeom prst="rect">
            <a:avLst/>
          </a:prstGeom>
          <a:ln w="0">
            <a:noFill/>
          </a:ln>
        </p:spPr>
      </p:pic>
      <p:sp>
        <p:nvSpPr>
          <p:cNvPr id="196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3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110160" y="533520"/>
            <a:ext cx="25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myotrophic lateral sclerosis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3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99" name=""/>
          <p:cNvGrpSpPr/>
          <p:nvPr/>
        </p:nvGrpSpPr>
        <p:grpSpPr>
          <a:xfrm>
            <a:off x="152280" y="762120"/>
            <a:ext cx="8763120" cy="5486400"/>
            <a:chOff x="152280" y="762120"/>
            <a:chExt cx="8763120" cy="5486400"/>
          </a:xfrm>
        </p:grpSpPr>
        <p:pic>
          <p:nvPicPr>
            <p:cNvPr id="200" name="" descr=""/>
            <p:cNvPicPr/>
            <p:nvPr/>
          </p:nvPicPr>
          <p:blipFill>
            <a:blip r:embed="rId1"/>
            <a:srcRect l="7208" t="12557" r="0" b="2681"/>
            <a:stretch/>
          </p:blipFill>
          <p:spPr>
            <a:xfrm>
              <a:off x="152280" y="838080"/>
              <a:ext cx="8763120" cy="5410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1" name=""/>
            <p:cNvSpPr/>
            <p:nvPr/>
          </p:nvSpPr>
          <p:spPr>
            <a:xfrm>
              <a:off x="153720" y="762120"/>
              <a:ext cx="328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ell-cycle G2/M DNA damage checkpoint regul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"/>
          <p:cNvSpPr/>
          <p:nvPr/>
        </p:nvSpPr>
        <p:spPr>
          <a:xfrm>
            <a:off x="689040" y="914400"/>
            <a:ext cx="8065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gnificant Canonical Pathways That Are Involved In Human Pituitary Adenoma Comparative Proteomic Dat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3200760" y="1523880"/>
            <a:ext cx="2754720" cy="163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1 Glutathion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2 Aryl hydrocarbon-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3 Oxidative phosphoryl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4 NRF2-mediated oxidative-stress respon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5 Pyruvate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6 TR/RXR activ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7 IGF-1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838080" y="3352680"/>
            <a:ext cx="7772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t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: (i)  A red label denotes an up-regulated protein, and a gray label denotes an down-regulated protein in pituitary adenoma,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with different color levels that reflect the fold-change of protein differential expressio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05" name=""/>
          <p:cNvGrpSpPr/>
          <p:nvPr/>
        </p:nvGrpSpPr>
        <p:grpSpPr>
          <a:xfrm>
            <a:off x="914400" y="3809880"/>
            <a:ext cx="7162920" cy="2760840"/>
            <a:chOff x="914400" y="3809880"/>
            <a:chExt cx="7162920" cy="2760840"/>
          </a:xfrm>
        </p:grpSpPr>
        <p:sp>
          <p:nvSpPr>
            <p:cNvPr id="206" name=""/>
            <p:cNvSpPr/>
            <p:nvPr/>
          </p:nvSpPr>
          <p:spPr>
            <a:xfrm>
              <a:off x="1219320" y="5943600"/>
              <a:ext cx="685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iv) An arrow (               ) denotes the pathway direction.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07" name=""/>
            <p:cNvGrpSpPr/>
            <p:nvPr/>
          </p:nvGrpSpPr>
          <p:grpSpPr>
            <a:xfrm>
              <a:off x="914400" y="3809880"/>
              <a:ext cx="6694200" cy="2760840"/>
              <a:chOff x="914400" y="3809880"/>
              <a:chExt cx="6694200" cy="2760840"/>
            </a:xfrm>
          </p:grpSpPr>
          <p:sp>
            <p:nvSpPr>
              <p:cNvPr id="208" name=""/>
              <p:cNvSpPr/>
              <p:nvPr/>
            </p:nvSpPr>
            <p:spPr>
              <a:xfrm>
                <a:off x="1295280" y="4191120"/>
                <a:ext cx="228600" cy="304560"/>
              </a:xfrm>
              <a:prstGeom prst="diamond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3124080" y="4191120"/>
                <a:ext cx="457200" cy="266760"/>
              </a:xfrm>
              <a:prstGeom prst="flowChartDecision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4648320" y="4191120"/>
                <a:ext cx="228600" cy="228600"/>
              </a:xfrm>
              <a:prstGeom prst="flowChartMerge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6095880" y="4191120"/>
                <a:ext cx="228600" cy="228600"/>
              </a:xfrm>
              <a:prstGeom prst="flowChartExtra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1295280" y="4724280"/>
                <a:ext cx="343080" cy="228600"/>
              </a:xfrm>
              <a:prstGeom prst="re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 rot="10800000">
                <a:off x="4648320" y="4647960"/>
                <a:ext cx="342720" cy="228600"/>
              </a:xfrm>
              <a:prstGeom prst="flowChartManualOperation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6095880" y="4572000"/>
                <a:ext cx="228600" cy="343080"/>
              </a:xfrm>
              <a:prstGeom prst="re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1295280" y="5257800"/>
                <a:ext cx="343080" cy="228600"/>
              </a:xfrm>
              <a:prstGeom prst="ellipse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3200400" y="4648320"/>
                <a:ext cx="380880" cy="304560"/>
              </a:xfrm>
              <a:prstGeom prst="roundRect">
                <a:avLst>
                  <a:gd name="adj" fmla="val 16667"/>
                </a:avLst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914400" y="3809880"/>
                <a:ext cx="4419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   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(ii)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he various shapes of nodes denote the different functions.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1600200" y="4191120"/>
                <a:ext cx="715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enzym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3579480" y="4191120"/>
                <a:ext cx="845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eptid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5029200" y="4191120"/>
                <a:ext cx="62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kin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6550200" y="4191120"/>
                <a:ext cx="1058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hosphat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1597320" y="4648320"/>
                <a:ext cx="1599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ytokine or regulator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3656520" y="4648320"/>
                <a:ext cx="886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etabolit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5028840" y="4648320"/>
                <a:ext cx="919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transporter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6627240" y="4648320"/>
                <a:ext cx="973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Ion channe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1676520" y="5257800"/>
                <a:ext cx="60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others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1219320" y="5638680"/>
                <a:ext cx="5105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(iii)  A duplicated shape means this node contains multiple components.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2209680" y="6095880"/>
                <a:ext cx="38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1222200" y="6324480"/>
                <a:ext cx="4473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(v)   A line with a small circle (                             ) denotes a biological result.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3200400" y="6477120"/>
                <a:ext cx="609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3809880" y="6400800"/>
                <a:ext cx="152640" cy="1461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7" name=""/>
          <p:cNvGrpSpPr/>
          <p:nvPr/>
        </p:nvGrpSpPr>
        <p:grpSpPr>
          <a:xfrm>
            <a:off x="137880" y="210960"/>
            <a:ext cx="8853840" cy="6265800"/>
            <a:chOff x="137880" y="210960"/>
            <a:chExt cx="8853840" cy="6265800"/>
          </a:xfrm>
        </p:grpSpPr>
        <p:pic>
          <p:nvPicPr>
            <p:cNvPr id="78" name="" descr=""/>
            <p:cNvPicPr/>
            <p:nvPr/>
          </p:nvPicPr>
          <p:blipFill>
            <a:blip r:embed="rId1"/>
            <a:srcRect l="5128" t="9596" r="0" b="2120"/>
            <a:stretch/>
          </p:blipFill>
          <p:spPr>
            <a:xfrm>
              <a:off x="152280" y="391680"/>
              <a:ext cx="8839440" cy="608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"/>
            <p:cNvSpPr/>
            <p:nvPr/>
          </p:nvSpPr>
          <p:spPr>
            <a:xfrm>
              <a:off x="137880" y="210960"/>
              <a:ext cx="932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itrate cycl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2.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33" name=""/>
          <p:cNvGrpSpPr/>
          <p:nvPr/>
        </p:nvGrpSpPr>
        <p:grpSpPr>
          <a:xfrm>
            <a:off x="152280" y="380880"/>
            <a:ext cx="8839440" cy="5943600"/>
            <a:chOff x="152280" y="380880"/>
            <a:chExt cx="8839440" cy="5943600"/>
          </a:xfrm>
        </p:grpSpPr>
        <p:pic>
          <p:nvPicPr>
            <p:cNvPr id="234" name="" descr=""/>
            <p:cNvPicPr/>
            <p:nvPr/>
          </p:nvPicPr>
          <p:blipFill>
            <a:blip r:embed="rId1"/>
            <a:srcRect l="6898" t="12184" r="0" b="2539"/>
            <a:stretch/>
          </p:blipFill>
          <p:spPr>
            <a:xfrm>
              <a:off x="152280" y="711360"/>
              <a:ext cx="8839440" cy="561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35" name=""/>
            <p:cNvSpPr/>
            <p:nvPr/>
          </p:nvSpPr>
          <p:spPr>
            <a:xfrm>
              <a:off x="153000" y="380880"/>
              <a:ext cx="1625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lutathione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6" name="" descr=""/>
          <p:cNvPicPr/>
          <p:nvPr/>
        </p:nvPicPr>
        <p:blipFill>
          <a:blip r:embed="rId1"/>
          <a:srcRect l="1770" t="4190" r="1770" b="1528"/>
          <a:stretch/>
        </p:blipFill>
        <p:spPr>
          <a:xfrm>
            <a:off x="152280" y="609480"/>
            <a:ext cx="8839440" cy="5486400"/>
          </a:xfrm>
          <a:prstGeom prst="rect">
            <a:avLst/>
          </a:prstGeom>
          <a:ln w="0">
            <a:noFill/>
          </a:ln>
        </p:spPr>
      </p:pic>
      <p:sp>
        <p:nvSpPr>
          <p:cNvPr id="237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2.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"/>
          <p:cNvSpPr/>
          <p:nvPr/>
        </p:nvSpPr>
        <p:spPr>
          <a:xfrm>
            <a:off x="154440" y="304920"/>
            <a:ext cx="237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ryl hydrocarbon-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2.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40" name=""/>
          <p:cNvGrpSpPr/>
          <p:nvPr/>
        </p:nvGrpSpPr>
        <p:grpSpPr>
          <a:xfrm>
            <a:off x="0" y="1066680"/>
            <a:ext cx="8839080" cy="4800600"/>
            <a:chOff x="0" y="1066680"/>
            <a:chExt cx="8839080" cy="4800600"/>
          </a:xfrm>
        </p:grpSpPr>
        <p:pic>
          <p:nvPicPr>
            <p:cNvPr id="241" name="" descr=""/>
            <p:cNvPicPr/>
            <p:nvPr/>
          </p:nvPicPr>
          <p:blipFill>
            <a:blip r:embed="rId1"/>
            <a:srcRect l="6957" t="15358" r="4346" b="4000"/>
            <a:stretch/>
          </p:blipFill>
          <p:spPr>
            <a:xfrm>
              <a:off x="0" y="1295280"/>
              <a:ext cx="88390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2" name=""/>
            <p:cNvSpPr/>
            <p:nvPr/>
          </p:nvSpPr>
          <p:spPr>
            <a:xfrm>
              <a:off x="153000" y="1066680"/>
              <a:ext cx="177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Oxidative phosphoryl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2.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44" name=""/>
          <p:cNvGrpSpPr/>
          <p:nvPr/>
        </p:nvGrpSpPr>
        <p:grpSpPr>
          <a:xfrm>
            <a:off x="1524960" y="152280"/>
            <a:ext cx="5713920" cy="6400800"/>
            <a:chOff x="1524960" y="152280"/>
            <a:chExt cx="5713920" cy="6400800"/>
          </a:xfrm>
        </p:grpSpPr>
        <p:pic>
          <p:nvPicPr>
            <p:cNvPr id="245" name="" descr=""/>
            <p:cNvPicPr/>
            <p:nvPr/>
          </p:nvPicPr>
          <p:blipFill>
            <a:blip r:embed="rId1"/>
            <a:srcRect l="7116" t="3615" r="8899" b="1206"/>
            <a:stretch/>
          </p:blipFill>
          <p:spPr>
            <a:xfrm>
              <a:off x="1600200" y="304920"/>
              <a:ext cx="5638680" cy="6248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6" name=""/>
            <p:cNvSpPr/>
            <p:nvPr/>
          </p:nvSpPr>
          <p:spPr>
            <a:xfrm>
              <a:off x="1524960" y="152280"/>
              <a:ext cx="2706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RF2-mediated oxidative-stress respons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2.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48" name=""/>
          <p:cNvGrpSpPr/>
          <p:nvPr/>
        </p:nvGrpSpPr>
        <p:grpSpPr>
          <a:xfrm>
            <a:off x="1066680" y="152280"/>
            <a:ext cx="6762960" cy="6477120"/>
            <a:chOff x="1066680" y="152280"/>
            <a:chExt cx="6762960" cy="6477120"/>
          </a:xfrm>
        </p:grpSpPr>
        <p:pic>
          <p:nvPicPr>
            <p:cNvPr id="249" name="" descr=""/>
            <p:cNvPicPr/>
            <p:nvPr/>
          </p:nvPicPr>
          <p:blipFill>
            <a:blip r:embed="rId1"/>
            <a:srcRect l="6300" t="6818" r="0" b="1137"/>
            <a:stretch/>
          </p:blipFill>
          <p:spPr>
            <a:xfrm>
              <a:off x="1066680" y="152280"/>
              <a:ext cx="6762960" cy="647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0" name=""/>
            <p:cNvSpPr/>
            <p:nvPr/>
          </p:nvSpPr>
          <p:spPr>
            <a:xfrm>
              <a:off x="1372680" y="152280"/>
              <a:ext cx="1453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yruvate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2.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52" name=""/>
          <p:cNvGrpSpPr/>
          <p:nvPr/>
        </p:nvGrpSpPr>
        <p:grpSpPr>
          <a:xfrm>
            <a:off x="152280" y="457200"/>
            <a:ext cx="8839440" cy="5562720"/>
            <a:chOff x="152280" y="457200"/>
            <a:chExt cx="8839440" cy="5562720"/>
          </a:xfrm>
        </p:grpSpPr>
        <p:pic>
          <p:nvPicPr>
            <p:cNvPr id="253" name="" descr=""/>
            <p:cNvPicPr/>
            <p:nvPr/>
          </p:nvPicPr>
          <p:blipFill>
            <a:blip r:embed="rId1"/>
            <a:srcRect l="4647" t="8708" r="1511" b="2468"/>
            <a:stretch/>
          </p:blipFill>
          <p:spPr>
            <a:xfrm>
              <a:off x="152280" y="762120"/>
              <a:ext cx="8839440" cy="525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4" name=""/>
            <p:cNvSpPr/>
            <p:nvPr/>
          </p:nvSpPr>
          <p:spPr>
            <a:xfrm>
              <a:off x="154440" y="457200"/>
              <a:ext cx="127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R/RXR activ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2.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56" name=""/>
          <p:cNvGrpSpPr/>
          <p:nvPr/>
        </p:nvGrpSpPr>
        <p:grpSpPr>
          <a:xfrm>
            <a:off x="457200" y="304920"/>
            <a:ext cx="8229600" cy="6324480"/>
            <a:chOff x="457200" y="304920"/>
            <a:chExt cx="8229600" cy="6324480"/>
          </a:xfrm>
        </p:grpSpPr>
        <p:pic>
          <p:nvPicPr>
            <p:cNvPr id="257" name="" descr=""/>
            <p:cNvPicPr/>
            <p:nvPr/>
          </p:nvPicPr>
          <p:blipFill>
            <a:blip r:embed="rId1"/>
            <a:srcRect l="8998" t="11642" r="2002" b="2205"/>
            <a:stretch/>
          </p:blipFill>
          <p:spPr>
            <a:xfrm>
              <a:off x="457200" y="357120"/>
              <a:ext cx="8229600" cy="6272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8" name=""/>
            <p:cNvSpPr/>
            <p:nvPr/>
          </p:nvSpPr>
          <p:spPr>
            <a:xfrm>
              <a:off x="610560" y="304920"/>
              <a:ext cx="109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GF-1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"/>
          <p:cNvSpPr/>
          <p:nvPr/>
        </p:nvSpPr>
        <p:spPr>
          <a:xfrm>
            <a:off x="986760" y="762120"/>
            <a:ext cx="7529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gnificant Canonical Pathways That Are Involved In Human Pituitary Adenoma Nitroproteomics Dat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0" name=""/>
          <p:cNvSpPr/>
          <p:nvPr/>
        </p:nvSpPr>
        <p:spPr>
          <a:xfrm>
            <a:off x="3126600" y="1295280"/>
            <a:ext cx="3312720" cy="232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1 Hepatic cholesta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2 Protein ubiquitination pathway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3 Sonic hedgehog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4 Cell-cycle G2/M DNA damage-checkpoint regula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5 GABA-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6 Toll-like 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7 Amyloid process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8 Phototransduction pathway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9 Sphingolipid metabolis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10 IL-10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1" name=""/>
          <p:cNvSpPr/>
          <p:nvPr/>
        </p:nvSpPr>
        <p:spPr>
          <a:xfrm>
            <a:off x="764640" y="3657600"/>
            <a:ext cx="570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t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:   (i)   A gray label denotes an identified nitroprotein or protein that interacts with nitroproteins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62" name=""/>
          <p:cNvGrpSpPr/>
          <p:nvPr/>
        </p:nvGrpSpPr>
        <p:grpSpPr>
          <a:xfrm>
            <a:off x="914400" y="3946680"/>
            <a:ext cx="7162920" cy="2760840"/>
            <a:chOff x="914400" y="3946680"/>
            <a:chExt cx="7162920" cy="2760840"/>
          </a:xfrm>
        </p:grpSpPr>
        <p:sp>
          <p:nvSpPr>
            <p:cNvPr id="263" name=""/>
            <p:cNvSpPr/>
            <p:nvPr/>
          </p:nvSpPr>
          <p:spPr>
            <a:xfrm>
              <a:off x="1219320" y="6080400"/>
              <a:ext cx="685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iv) An arrow (               ) denotes the pathway direction.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64" name=""/>
            <p:cNvGrpSpPr/>
            <p:nvPr/>
          </p:nvGrpSpPr>
          <p:grpSpPr>
            <a:xfrm>
              <a:off x="914400" y="3946680"/>
              <a:ext cx="6694200" cy="2760840"/>
              <a:chOff x="914400" y="3946680"/>
              <a:chExt cx="6694200" cy="2760840"/>
            </a:xfrm>
          </p:grpSpPr>
          <p:sp>
            <p:nvSpPr>
              <p:cNvPr id="265" name=""/>
              <p:cNvSpPr/>
              <p:nvPr/>
            </p:nvSpPr>
            <p:spPr>
              <a:xfrm>
                <a:off x="1295280" y="4327920"/>
                <a:ext cx="228600" cy="304560"/>
              </a:xfrm>
              <a:prstGeom prst="diamond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3124080" y="4327920"/>
                <a:ext cx="457200" cy="266760"/>
              </a:xfrm>
              <a:prstGeom prst="flowChartDecision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4648320" y="4327920"/>
                <a:ext cx="228600" cy="228600"/>
              </a:xfrm>
              <a:prstGeom prst="flowChartMerge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6095880" y="4327920"/>
                <a:ext cx="228600" cy="228600"/>
              </a:xfrm>
              <a:prstGeom prst="flowChartExtra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1295280" y="4861080"/>
                <a:ext cx="343080" cy="228600"/>
              </a:xfrm>
              <a:prstGeom prst="re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 rot="10800000">
                <a:off x="4648320" y="4784760"/>
                <a:ext cx="342720" cy="228600"/>
              </a:xfrm>
              <a:prstGeom prst="flowChartManualOperation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6095880" y="4708800"/>
                <a:ext cx="228600" cy="343080"/>
              </a:xfrm>
              <a:prstGeom prst="re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1295280" y="5394600"/>
                <a:ext cx="343080" cy="228600"/>
              </a:xfrm>
              <a:prstGeom prst="ellipse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3200400" y="4785120"/>
                <a:ext cx="380880" cy="304560"/>
              </a:xfrm>
              <a:prstGeom prst="roundRect">
                <a:avLst>
                  <a:gd name="adj" fmla="val 16667"/>
                </a:avLst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914400" y="3946680"/>
                <a:ext cx="4419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   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(ii)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he various shapes of nodes denote the different functions.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1600200" y="4327920"/>
                <a:ext cx="715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enzym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3579480" y="4327920"/>
                <a:ext cx="845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eptid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5029200" y="4327920"/>
                <a:ext cx="62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kin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6550200" y="4327920"/>
                <a:ext cx="1058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hosphat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1597320" y="4785120"/>
                <a:ext cx="1599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ytokine or regulator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3656520" y="4785120"/>
                <a:ext cx="886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etabolit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5028840" y="4785120"/>
                <a:ext cx="919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transporter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6627240" y="4785120"/>
                <a:ext cx="973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Ion channe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1676520" y="5394600"/>
                <a:ext cx="60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others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1219320" y="5775480"/>
                <a:ext cx="5105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(iii) A duplicated shape means this node contains multiple components.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2209680" y="6232680"/>
                <a:ext cx="38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1222200" y="6461280"/>
                <a:ext cx="4508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(v)  A line with a small circle (                               ) denotes a biological result.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3200400" y="6613920"/>
                <a:ext cx="609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3809880" y="6537600"/>
                <a:ext cx="152640" cy="1461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90" name=""/>
          <p:cNvGrpSpPr/>
          <p:nvPr/>
        </p:nvGrpSpPr>
        <p:grpSpPr>
          <a:xfrm>
            <a:off x="152280" y="152280"/>
            <a:ext cx="8839440" cy="6400800"/>
            <a:chOff x="152280" y="152280"/>
            <a:chExt cx="8839440" cy="6400800"/>
          </a:xfrm>
        </p:grpSpPr>
        <p:pic>
          <p:nvPicPr>
            <p:cNvPr id="291" name="" descr=""/>
            <p:cNvPicPr/>
            <p:nvPr/>
          </p:nvPicPr>
          <p:blipFill>
            <a:blip r:embed="rId1"/>
            <a:srcRect l="3193" t="3615" r="0" b="1206"/>
            <a:stretch/>
          </p:blipFill>
          <p:spPr>
            <a:xfrm>
              <a:off x="152280" y="192240"/>
              <a:ext cx="8839440" cy="6360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92" name=""/>
            <p:cNvSpPr/>
            <p:nvPr/>
          </p:nvSpPr>
          <p:spPr>
            <a:xfrm>
              <a:off x="229320" y="152280"/>
              <a:ext cx="1361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epatic cholestas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94" name=""/>
          <p:cNvGrpSpPr/>
          <p:nvPr/>
        </p:nvGrpSpPr>
        <p:grpSpPr>
          <a:xfrm>
            <a:off x="610920" y="152280"/>
            <a:ext cx="7695000" cy="6477120"/>
            <a:chOff x="610920" y="152280"/>
            <a:chExt cx="7695000" cy="6477120"/>
          </a:xfrm>
        </p:grpSpPr>
        <p:pic>
          <p:nvPicPr>
            <p:cNvPr id="295" name="" descr=""/>
            <p:cNvPicPr/>
            <p:nvPr/>
          </p:nvPicPr>
          <p:blipFill>
            <a:blip r:embed="rId1"/>
            <a:srcRect l="5441" t="5952" r="0" b="1190"/>
            <a:stretch/>
          </p:blipFill>
          <p:spPr>
            <a:xfrm>
              <a:off x="685800" y="380880"/>
              <a:ext cx="7620120" cy="624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96" name=""/>
            <p:cNvSpPr/>
            <p:nvPr/>
          </p:nvSpPr>
          <p:spPr>
            <a:xfrm>
              <a:off x="610920" y="152280"/>
              <a:ext cx="203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rotein ubiquitination pathwa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1" name=""/>
          <p:cNvGrpSpPr/>
          <p:nvPr/>
        </p:nvGrpSpPr>
        <p:grpSpPr>
          <a:xfrm>
            <a:off x="214200" y="131760"/>
            <a:ext cx="8777520" cy="6421320"/>
            <a:chOff x="214200" y="131760"/>
            <a:chExt cx="8777520" cy="6421320"/>
          </a:xfrm>
        </p:grpSpPr>
        <p:pic>
          <p:nvPicPr>
            <p:cNvPr id="82" name="" descr=""/>
            <p:cNvPicPr/>
            <p:nvPr/>
          </p:nvPicPr>
          <p:blipFill>
            <a:blip r:embed="rId1"/>
            <a:srcRect l="7341" t="10663" r="0" b="1679"/>
            <a:stretch/>
          </p:blipFill>
          <p:spPr>
            <a:xfrm>
              <a:off x="228600" y="131760"/>
              <a:ext cx="8763120" cy="6421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"/>
            <p:cNvSpPr/>
            <p:nvPr/>
          </p:nvSpPr>
          <p:spPr>
            <a:xfrm>
              <a:off x="214200" y="135000"/>
              <a:ext cx="14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thane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7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98" name=""/>
          <p:cNvGrpSpPr/>
          <p:nvPr/>
        </p:nvGrpSpPr>
        <p:grpSpPr>
          <a:xfrm>
            <a:off x="457200" y="228600"/>
            <a:ext cx="8229600" cy="6326280"/>
            <a:chOff x="457200" y="228600"/>
            <a:chExt cx="8229600" cy="6326280"/>
          </a:xfrm>
        </p:grpSpPr>
        <p:pic>
          <p:nvPicPr>
            <p:cNvPr id="299" name="" descr=""/>
            <p:cNvPicPr/>
            <p:nvPr/>
          </p:nvPicPr>
          <p:blipFill>
            <a:blip r:embed="rId1"/>
            <a:srcRect l="11882" t="14792" r="0" b="2620"/>
            <a:stretch/>
          </p:blipFill>
          <p:spPr>
            <a:xfrm>
              <a:off x="457200" y="473040"/>
              <a:ext cx="8229600" cy="6081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00" name=""/>
            <p:cNvSpPr/>
            <p:nvPr/>
          </p:nvSpPr>
          <p:spPr>
            <a:xfrm>
              <a:off x="458280" y="228600"/>
              <a:ext cx="1758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onic hedgehog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02" name=""/>
          <p:cNvGrpSpPr/>
          <p:nvPr/>
        </p:nvGrpSpPr>
        <p:grpSpPr>
          <a:xfrm>
            <a:off x="152280" y="762120"/>
            <a:ext cx="8686800" cy="5333760"/>
            <a:chOff x="152280" y="762120"/>
            <a:chExt cx="8686800" cy="5333760"/>
          </a:xfrm>
        </p:grpSpPr>
        <p:pic>
          <p:nvPicPr>
            <p:cNvPr id="303" name="" descr=""/>
            <p:cNvPicPr/>
            <p:nvPr/>
          </p:nvPicPr>
          <p:blipFill>
            <a:blip r:embed="rId1"/>
            <a:srcRect l="7208" t="12898" r="0" b="3257"/>
            <a:stretch/>
          </p:blipFill>
          <p:spPr>
            <a:xfrm>
              <a:off x="152280" y="871560"/>
              <a:ext cx="8686800" cy="5224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04" name=""/>
            <p:cNvSpPr/>
            <p:nvPr/>
          </p:nvSpPr>
          <p:spPr>
            <a:xfrm>
              <a:off x="230040" y="762120"/>
              <a:ext cx="3297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ell-cycle G2/M DNA damage-checkpoint regul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5" name="" descr=""/>
          <p:cNvPicPr/>
          <p:nvPr/>
        </p:nvPicPr>
        <p:blipFill>
          <a:blip r:embed="rId1"/>
          <a:srcRect l="7408" t="8197" r="0" b="1635"/>
          <a:stretch/>
        </p:blipFill>
        <p:spPr>
          <a:xfrm>
            <a:off x="228600" y="380880"/>
            <a:ext cx="8686800" cy="6172200"/>
          </a:xfrm>
          <a:prstGeom prst="rect">
            <a:avLst/>
          </a:prstGeom>
          <a:ln w="0">
            <a:noFill/>
          </a:ln>
        </p:spPr>
      </p:pic>
      <p:sp>
        <p:nvSpPr>
          <p:cNvPr id="306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7" name=""/>
          <p:cNvSpPr/>
          <p:nvPr/>
        </p:nvSpPr>
        <p:spPr>
          <a:xfrm>
            <a:off x="383040" y="152280"/>
            <a:ext cx="169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ABA-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" name="" descr=""/>
          <p:cNvPicPr/>
          <p:nvPr/>
        </p:nvPicPr>
        <p:blipFill>
          <a:blip r:embed="rId1"/>
          <a:srcRect l="13761" t="12186" r="2753" b="2692"/>
          <a:stretch/>
        </p:blipFill>
        <p:spPr>
          <a:xfrm>
            <a:off x="685800" y="380880"/>
            <a:ext cx="8077320" cy="6199200"/>
          </a:xfrm>
          <a:prstGeom prst="rect">
            <a:avLst/>
          </a:prstGeom>
          <a:ln w="0">
            <a:noFill/>
          </a:ln>
        </p:spPr>
      </p:pic>
      <p:sp>
        <p:nvSpPr>
          <p:cNvPr id="309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0" name=""/>
          <p:cNvSpPr/>
          <p:nvPr/>
        </p:nvSpPr>
        <p:spPr>
          <a:xfrm>
            <a:off x="534600" y="228600"/>
            <a:ext cx="1791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oll-like receptor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12" name=""/>
          <p:cNvGrpSpPr/>
          <p:nvPr/>
        </p:nvGrpSpPr>
        <p:grpSpPr>
          <a:xfrm>
            <a:off x="152280" y="457200"/>
            <a:ext cx="8686800" cy="5943600"/>
            <a:chOff x="152280" y="457200"/>
            <a:chExt cx="8686800" cy="5943600"/>
          </a:xfrm>
        </p:grpSpPr>
        <p:pic>
          <p:nvPicPr>
            <p:cNvPr id="313" name="" descr=""/>
            <p:cNvPicPr/>
            <p:nvPr/>
          </p:nvPicPr>
          <p:blipFill>
            <a:blip r:embed="rId1"/>
            <a:srcRect l="10714" t="16319" r="894" b="3349"/>
            <a:stretch/>
          </p:blipFill>
          <p:spPr>
            <a:xfrm>
              <a:off x="152280" y="557280"/>
              <a:ext cx="8686800" cy="584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14" name=""/>
            <p:cNvSpPr/>
            <p:nvPr/>
          </p:nvSpPr>
          <p:spPr>
            <a:xfrm>
              <a:off x="230040" y="457200"/>
              <a:ext cx="139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myloid process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16" name=""/>
          <p:cNvGrpSpPr/>
          <p:nvPr/>
        </p:nvGrpSpPr>
        <p:grpSpPr>
          <a:xfrm>
            <a:off x="609480" y="152280"/>
            <a:ext cx="7543800" cy="6477120"/>
            <a:chOff x="609480" y="152280"/>
            <a:chExt cx="7543800" cy="6477120"/>
          </a:xfrm>
        </p:grpSpPr>
        <p:pic>
          <p:nvPicPr>
            <p:cNvPr id="317" name="" descr=""/>
            <p:cNvPicPr/>
            <p:nvPr/>
          </p:nvPicPr>
          <p:blipFill>
            <a:blip r:embed="rId1"/>
            <a:srcRect l="7805" t="8140" r="0" b="4409"/>
            <a:stretch/>
          </p:blipFill>
          <p:spPr>
            <a:xfrm>
              <a:off x="609480" y="380880"/>
              <a:ext cx="7543800" cy="624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18" name=""/>
            <p:cNvSpPr/>
            <p:nvPr/>
          </p:nvSpPr>
          <p:spPr>
            <a:xfrm>
              <a:off x="610920" y="152280"/>
              <a:ext cx="1851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hototransduction pathwa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20" name=""/>
          <p:cNvGrpSpPr/>
          <p:nvPr/>
        </p:nvGrpSpPr>
        <p:grpSpPr>
          <a:xfrm>
            <a:off x="228600" y="152280"/>
            <a:ext cx="8686800" cy="6400800"/>
            <a:chOff x="228600" y="152280"/>
            <a:chExt cx="8686800" cy="6400800"/>
          </a:xfrm>
        </p:grpSpPr>
        <p:pic>
          <p:nvPicPr>
            <p:cNvPr id="321" name="" descr=""/>
            <p:cNvPicPr/>
            <p:nvPr/>
          </p:nvPicPr>
          <p:blipFill>
            <a:blip r:embed="rId1"/>
            <a:srcRect l="7274" t="11620" r="0" b="2397"/>
            <a:stretch/>
          </p:blipFill>
          <p:spPr>
            <a:xfrm>
              <a:off x="228600" y="361800"/>
              <a:ext cx="8686800" cy="6191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2" name=""/>
            <p:cNvSpPr/>
            <p:nvPr/>
          </p:nvSpPr>
          <p:spPr>
            <a:xfrm>
              <a:off x="306000" y="152280"/>
              <a:ext cx="1688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phingolipid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.1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24" name=""/>
          <p:cNvGrpSpPr/>
          <p:nvPr/>
        </p:nvGrpSpPr>
        <p:grpSpPr>
          <a:xfrm>
            <a:off x="304920" y="228600"/>
            <a:ext cx="8610480" cy="6350040"/>
            <a:chOff x="304920" y="228600"/>
            <a:chExt cx="8610480" cy="6350040"/>
          </a:xfrm>
        </p:grpSpPr>
        <p:pic>
          <p:nvPicPr>
            <p:cNvPr id="325" name="" descr=""/>
            <p:cNvPicPr/>
            <p:nvPr/>
          </p:nvPicPr>
          <p:blipFill>
            <a:blip r:embed="rId1"/>
            <a:srcRect l="9009" t="10664" r="1802" b="2841"/>
            <a:stretch/>
          </p:blipFill>
          <p:spPr>
            <a:xfrm>
              <a:off x="304920" y="228600"/>
              <a:ext cx="8610480" cy="6350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6" name=""/>
            <p:cNvSpPr/>
            <p:nvPr/>
          </p:nvSpPr>
          <p:spPr>
            <a:xfrm>
              <a:off x="306000" y="228600"/>
              <a:ext cx="1067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L-10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" name=""/>
          <p:cNvSpPr/>
          <p:nvPr/>
        </p:nvSpPr>
        <p:spPr>
          <a:xfrm>
            <a:off x="911880" y="304920"/>
            <a:ext cx="7375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gnificant Canonical Pathways That Are Involved In Human Pituitary Control Nitroproteomics Dat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8" name=""/>
          <p:cNvSpPr/>
          <p:nvPr/>
        </p:nvSpPr>
        <p:spPr>
          <a:xfrm>
            <a:off x="2893320" y="762120"/>
            <a:ext cx="4258800" cy="279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1 Clatrin-mediated endocyto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2 Caveolar-mediated endocytosi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3 VEGF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4 Regulation of actin-based motility by Rho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5 Fcy receptor-mediated phagocytosis in macrophages and monocy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6 Tight-junction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7 NRF2-mediated oxidative stress respon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8 Leukocyte extravasation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9 Integrin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10 Actin cytoskeleton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11 Calcium signal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12 Nitric oxide signaling in the cardiovascular syste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9" name=""/>
          <p:cNvSpPr/>
          <p:nvPr/>
        </p:nvSpPr>
        <p:spPr>
          <a:xfrm>
            <a:off x="993600" y="3581280"/>
            <a:ext cx="324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t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: (i) A gray label denotes an identified nitroprotein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30" name=""/>
          <p:cNvGrpSpPr/>
          <p:nvPr/>
        </p:nvGrpSpPr>
        <p:grpSpPr>
          <a:xfrm>
            <a:off x="1066680" y="3886200"/>
            <a:ext cx="7162920" cy="2760840"/>
            <a:chOff x="1066680" y="3886200"/>
            <a:chExt cx="7162920" cy="2760840"/>
          </a:xfrm>
        </p:grpSpPr>
        <p:sp>
          <p:nvSpPr>
            <p:cNvPr id="331" name=""/>
            <p:cNvSpPr/>
            <p:nvPr/>
          </p:nvSpPr>
          <p:spPr>
            <a:xfrm>
              <a:off x="1371600" y="6019920"/>
              <a:ext cx="685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iv)  An arrow (               ) denotes the pathway direction.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332" name=""/>
            <p:cNvGrpSpPr/>
            <p:nvPr/>
          </p:nvGrpSpPr>
          <p:grpSpPr>
            <a:xfrm>
              <a:off x="1066680" y="3886200"/>
              <a:ext cx="6694200" cy="2760840"/>
              <a:chOff x="1066680" y="3886200"/>
              <a:chExt cx="6694200" cy="2760840"/>
            </a:xfrm>
          </p:grpSpPr>
          <p:sp>
            <p:nvSpPr>
              <p:cNvPr id="333" name=""/>
              <p:cNvSpPr/>
              <p:nvPr/>
            </p:nvSpPr>
            <p:spPr>
              <a:xfrm>
                <a:off x="1447560" y="4267440"/>
                <a:ext cx="228600" cy="304560"/>
              </a:xfrm>
              <a:prstGeom prst="diamond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3276360" y="4267440"/>
                <a:ext cx="457200" cy="266760"/>
              </a:xfrm>
              <a:prstGeom prst="flowChartDecision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4800600" y="4267440"/>
                <a:ext cx="228600" cy="228600"/>
              </a:xfrm>
              <a:prstGeom prst="flowChartMerge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6248160" y="4267440"/>
                <a:ext cx="228600" cy="228600"/>
              </a:xfrm>
              <a:prstGeom prst="flowChartExtra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1447560" y="4800600"/>
                <a:ext cx="343080" cy="228600"/>
              </a:xfrm>
              <a:prstGeom prst="re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 rot="10800000">
                <a:off x="4800600" y="4724280"/>
                <a:ext cx="342720" cy="228600"/>
              </a:xfrm>
              <a:prstGeom prst="flowChartManualOperation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6248160" y="4648320"/>
                <a:ext cx="228600" cy="343080"/>
              </a:xfrm>
              <a:prstGeom prst="rect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1447560" y="5334120"/>
                <a:ext cx="343080" cy="228600"/>
              </a:xfrm>
              <a:prstGeom prst="ellipse">
                <a:avLst/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3352680" y="4724640"/>
                <a:ext cx="380880" cy="304560"/>
              </a:xfrm>
              <a:prstGeom prst="roundRect">
                <a:avLst>
                  <a:gd name="adj" fmla="val 16667"/>
                </a:avLst>
              </a:prstGeom>
              <a:solidFill>
                <a:srgbClr val="ffffff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1066680" y="3886200"/>
                <a:ext cx="4419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   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(ii)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he various shapes of nodes denote the different functions.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1752480" y="4267440"/>
                <a:ext cx="715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enzym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3731760" y="4267440"/>
                <a:ext cx="845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eptid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5181480" y="4267440"/>
                <a:ext cx="62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kin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6702480" y="4267440"/>
                <a:ext cx="1058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hosphata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1749600" y="4724640"/>
                <a:ext cx="1599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ytokine or regulator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3808800" y="4724640"/>
                <a:ext cx="886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etabolit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5181120" y="4724640"/>
                <a:ext cx="919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transporter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6779520" y="4724640"/>
                <a:ext cx="973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Ion channe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1828800" y="5334120"/>
                <a:ext cx="60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others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1371600" y="5715000"/>
                <a:ext cx="5105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(iii)  A duplicated shape means this node contains multiple components.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>
                <a:off x="2361960" y="6172200"/>
                <a:ext cx="38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1374480" y="6400800"/>
                <a:ext cx="4543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(v)   A line with a small circle (                               ) denotes a biological result.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>
                <a:off x="3352680" y="6553440"/>
                <a:ext cx="609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3962160" y="6477120"/>
                <a:ext cx="152640" cy="1461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58" name=""/>
          <p:cNvGrpSpPr/>
          <p:nvPr/>
        </p:nvGrpSpPr>
        <p:grpSpPr>
          <a:xfrm>
            <a:off x="152280" y="380880"/>
            <a:ext cx="8839440" cy="5867640"/>
            <a:chOff x="152280" y="380880"/>
            <a:chExt cx="8839440" cy="5867640"/>
          </a:xfrm>
        </p:grpSpPr>
        <p:pic>
          <p:nvPicPr>
            <p:cNvPr id="359" name="" descr=""/>
            <p:cNvPicPr/>
            <p:nvPr/>
          </p:nvPicPr>
          <p:blipFill>
            <a:blip r:embed="rId1"/>
            <a:srcRect l="0" t="11159" r="0" b="2758"/>
            <a:stretch/>
          </p:blipFill>
          <p:spPr>
            <a:xfrm>
              <a:off x="152280" y="609480"/>
              <a:ext cx="8839440" cy="563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60" name=""/>
            <p:cNvSpPr/>
            <p:nvPr/>
          </p:nvSpPr>
          <p:spPr>
            <a:xfrm>
              <a:off x="153720" y="380880"/>
              <a:ext cx="195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latrin-mediated endocytos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5" name=""/>
          <p:cNvGrpSpPr/>
          <p:nvPr/>
        </p:nvGrpSpPr>
        <p:grpSpPr>
          <a:xfrm>
            <a:off x="137160" y="135000"/>
            <a:ext cx="8854560" cy="6417720"/>
            <a:chOff x="137160" y="135000"/>
            <a:chExt cx="8854560" cy="6417720"/>
          </a:xfrm>
        </p:grpSpPr>
        <p:pic>
          <p:nvPicPr>
            <p:cNvPr id="86" name="" descr=""/>
            <p:cNvPicPr/>
            <p:nvPr/>
          </p:nvPicPr>
          <p:blipFill>
            <a:blip r:embed="rId1"/>
            <a:srcRect l="7018" t="11968" r="0" b="2153"/>
            <a:stretch/>
          </p:blipFill>
          <p:spPr>
            <a:xfrm>
              <a:off x="152280" y="383760"/>
              <a:ext cx="8839440" cy="6168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"/>
            <p:cNvSpPr/>
            <p:nvPr/>
          </p:nvSpPr>
          <p:spPr>
            <a:xfrm>
              <a:off x="137160" y="135000"/>
              <a:ext cx="1625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lutathione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62" name=""/>
          <p:cNvGrpSpPr/>
          <p:nvPr/>
        </p:nvGrpSpPr>
        <p:grpSpPr>
          <a:xfrm>
            <a:off x="914400" y="152280"/>
            <a:ext cx="7391520" cy="6464520"/>
            <a:chOff x="914400" y="152280"/>
            <a:chExt cx="7391520" cy="6464520"/>
          </a:xfrm>
        </p:grpSpPr>
        <p:pic>
          <p:nvPicPr>
            <p:cNvPr id="363" name="" descr=""/>
            <p:cNvPicPr/>
            <p:nvPr/>
          </p:nvPicPr>
          <p:blipFill>
            <a:blip r:embed="rId1"/>
            <a:srcRect l="0" t="10909" r="0" b="1820"/>
            <a:stretch/>
          </p:blipFill>
          <p:spPr>
            <a:xfrm>
              <a:off x="914400" y="457200"/>
              <a:ext cx="7391520" cy="615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64" name=""/>
            <p:cNvSpPr/>
            <p:nvPr/>
          </p:nvSpPr>
          <p:spPr>
            <a:xfrm>
              <a:off x="991440" y="152280"/>
              <a:ext cx="2087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aveolar-mediated endocytos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66" name=""/>
          <p:cNvGrpSpPr/>
          <p:nvPr/>
        </p:nvGrpSpPr>
        <p:grpSpPr>
          <a:xfrm>
            <a:off x="1066680" y="152280"/>
            <a:ext cx="6553440" cy="6477120"/>
            <a:chOff x="1066680" y="152280"/>
            <a:chExt cx="6553440" cy="6477120"/>
          </a:xfrm>
        </p:grpSpPr>
        <p:pic>
          <p:nvPicPr>
            <p:cNvPr id="367" name="" descr=""/>
            <p:cNvPicPr/>
            <p:nvPr/>
          </p:nvPicPr>
          <p:blipFill>
            <a:blip r:embed="rId1"/>
            <a:srcRect l="7849" t="8332" r="0" b="1190"/>
            <a:stretch/>
          </p:blipFill>
          <p:spPr>
            <a:xfrm>
              <a:off x="1066680" y="380880"/>
              <a:ext cx="6553440" cy="624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68" name=""/>
            <p:cNvSpPr/>
            <p:nvPr/>
          </p:nvSpPr>
          <p:spPr>
            <a:xfrm>
              <a:off x="1068120" y="152280"/>
              <a:ext cx="111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VEGF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70" name=""/>
          <p:cNvGrpSpPr/>
          <p:nvPr/>
        </p:nvGrpSpPr>
        <p:grpSpPr>
          <a:xfrm>
            <a:off x="762120" y="152280"/>
            <a:ext cx="7696080" cy="6400800"/>
            <a:chOff x="762120" y="152280"/>
            <a:chExt cx="7696080" cy="6400800"/>
          </a:xfrm>
        </p:grpSpPr>
        <p:pic>
          <p:nvPicPr>
            <p:cNvPr id="371" name="" descr=""/>
            <p:cNvPicPr/>
            <p:nvPr/>
          </p:nvPicPr>
          <p:blipFill>
            <a:blip r:embed="rId1"/>
            <a:srcRect l="10991" t="12750" r="1099" b="2634"/>
            <a:stretch/>
          </p:blipFill>
          <p:spPr>
            <a:xfrm>
              <a:off x="762120" y="380880"/>
              <a:ext cx="7696080" cy="617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72" name=""/>
            <p:cNvSpPr/>
            <p:nvPr/>
          </p:nvSpPr>
          <p:spPr>
            <a:xfrm>
              <a:off x="763560" y="152280"/>
              <a:ext cx="268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gulation of actin-based motility by Rh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74" name=""/>
          <p:cNvGrpSpPr/>
          <p:nvPr/>
        </p:nvGrpSpPr>
        <p:grpSpPr>
          <a:xfrm>
            <a:off x="152280" y="685800"/>
            <a:ext cx="8839440" cy="5181480"/>
            <a:chOff x="152280" y="685800"/>
            <a:chExt cx="8839440" cy="5181480"/>
          </a:xfrm>
        </p:grpSpPr>
        <p:pic>
          <p:nvPicPr>
            <p:cNvPr id="375" name="" descr=""/>
            <p:cNvPicPr/>
            <p:nvPr/>
          </p:nvPicPr>
          <p:blipFill>
            <a:blip r:embed="rId1"/>
            <a:srcRect l="2727" t="9260" r="0" b="1851"/>
            <a:stretch/>
          </p:blipFill>
          <p:spPr>
            <a:xfrm>
              <a:off x="152280" y="990720"/>
              <a:ext cx="8839440" cy="4876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76" name=""/>
            <p:cNvSpPr/>
            <p:nvPr/>
          </p:nvSpPr>
          <p:spPr>
            <a:xfrm>
              <a:off x="228600" y="685800"/>
              <a:ext cx="4361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cy receptor-mediated phagocytosis in macrophages and monocyte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78" name=""/>
          <p:cNvGrpSpPr/>
          <p:nvPr/>
        </p:nvGrpSpPr>
        <p:grpSpPr>
          <a:xfrm>
            <a:off x="990720" y="228600"/>
            <a:ext cx="7162560" cy="6324480"/>
            <a:chOff x="990720" y="228600"/>
            <a:chExt cx="7162560" cy="6324480"/>
          </a:xfrm>
        </p:grpSpPr>
        <p:pic>
          <p:nvPicPr>
            <p:cNvPr id="379" name="" descr=""/>
            <p:cNvPicPr/>
            <p:nvPr/>
          </p:nvPicPr>
          <p:blipFill>
            <a:blip r:embed="rId1"/>
            <a:srcRect l="7643" t="7058" r="0" b="3530"/>
            <a:stretch/>
          </p:blipFill>
          <p:spPr>
            <a:xfrm>
              <a:off x="990720" y="457200"/>
              <a:ext cx="7162560" cy="6095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80" name=""/>
            <p:cNvSpPr/>
            <p:nvPr/>
          </p:nvSpPr>
          <p:spPr>
            <a:xfrm>
              <a:off x="1068120" y="228600"/>
              <a:ext cx="1619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ight-junction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82" name=""/>
          <p:cNvGrpSpPr/>
          <p:nvPr/>
        </p:nvGrpSpPr>
        <p:grpSpPr>
          <a:xfrm>
            <a:off x="1447920" y="60480"/>
            <a:ext cx="5867280" cy="6492600"/>
            <a:chOff x="1447920" y="60480"/>
            <a:chExt cx="5867280" cy="6492600"/>
          </a:xfrm>
        </p:grpSpPr>
        <p:pic>
          <p:nvPicPr>
            <p:cNvPr id="383" name="" descr=""/>
            <p:cNvPicPr/>
            <p:nvPr/>
          </p:nvPicPr>
          <p:blipFill>
            <a:blip r:embed="rId1"/>
            <a:srcRect l="5685" t="3572" r="0" b="1190"/>
            <a:stretch/>
          </p:blipFill>
          <p:spPr>
            <a:xfrm>
              <a:off x="1447920" y="304920"/>
              <a:ext cx="5867280" cy="6248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84" name=""/>
            <p:cNvSpPr/>
            <p:nvPr/>
          </p:nvSpPr>
          <p:spPr>
            <a:xfrm>
              <a:off x="1524960" y="60480"/>
              <a:ext cx="2698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RF2-mediated oxidative stress respons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86" name=""/>
          <p:cNvGrpSpPr/>
          <p:nvPr/>
        </p:nvGrpSpPr>
        <p:grpSpPr>
          <a:xfrm>
            <a:off x="228600" y="152280"/>
            <a:ext cx="8763120" cy="6400800"/>
            <a:chOff x="228600" y="152280"/>
            <a:chExt cx="8763120" cy="6400800"/>
          </a:xfrm>
        </p:grpSpPr>
        <p:pic>
          <p:nvPicPr>
            <p:cNvPr id="387" name="" descr=""/>
            <p:cNvPicPr/>
            <p:nvPr/>
          </p:nvPicPr>
          <p:blipFill>
            <a:blip r:embed="rId1"/>
            <a:srcRect l="7206" t="10779" r="0" b="1627"/>
            <a:stretch/>
          </p:blipFill>
          <p:spPr>
            <a:xfrm>
              <a:off x="228600" y="228600"/>
              <a:ext cx="8763120" cy="6324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88" name=""/>
            <p:cNvSpPr/>
            <p:nvPr/>
          </p:nvSpPr>
          <p:spPr>
            <a:xfrm>
              <a:off x="228960" y="152280"/>
              <a:ext cx="224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eukocyte extravasation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90" name=""/>
          <p:cNvGrpSpPr/>
          <p:nvPr/>
        </p:nvGrpSpPr>
        <p:grpSpPr>
          <a:xfrm>
            <a:off x="152280" y="762120"/>
            <a:ext cx="8839440" cy="5181480"/>
            <a:chOff x="152280" y="762120"/>
            <a:chExt cx="8839440" cy="5181480"/>
          </a:xfrm>
        </p:grpSpPr>
        <p:pic>
          <p:nvPicPr>
            <p:cNvPr id="391" name="" descr=""/>
            <p:cNvPicPr/>
            <p:nvPr/>
          </p:nvPicPr>
          <p:blipFill>
            <a:blip r:embed="rId1"/>
            <a:srcRect l="888" t="12784" r="0" b="1371"/>
            <a:stretch/>
          </p:blipFill>
          <p:spPr>
            <a:xfrm>
              <a:off x="152280" y="914400"/>
              <a:ext cx="8839440" cy="502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2" name=""/>
            <p:cNvSpPr/>
            <p:nvPr/>
          </p:nvSpPr>
          <p:spPr>
            <a:xfrm>
              <a:off x="153720" y="762120"/>
              <a:ext cx="1236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ntegrin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1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94" name=""/>
          <p:cNvGrpSpPr/>
          <p:nvPr/>
        </p:nvGrpSpPr>
        <p:grpSpPr>
          <a:xfrm>
            <a:off x="228600" y="228600"/>
            <a:ext cx="8686800" cy="6400800"/>
            <a:chOff x="228600" y="228600"/>
            <a:chExt cx="8686800" cy="6400800"/>
          </a:xfrm>
        </p:grpSpPr>
        <p:pic>
          <p:nvPicPr>
            <p:cNvPr id="395" name="" descr=""/>
            <p:cNvPicPr/>
            <p:nvPr/>
          </p:nvPicPr>
          <p:blipFill>
            <a:blip r:embed="rId1"/>
            <a:srcRect l="8037" t="11000" r="0" b="2240"/>
            <a:stretch/>
          </p:blipFill>
          <p:spPr>
            <a:xfrm>
              <a:off x="228600" y="228600"/>
              <a:ext cx="8686800" cy="6400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6" name=""/>
            <p:cNvSpPr/>
            <p:nvPr/>
          </p:nvSpPr>
          <p:spPr>
            <a:xfrm>
              <a:off x="229320" y="228600"/>
              <a:ext cx="189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ctin cytoskeleton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1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98" name=""/>
          <p:cNvGrpSpPr/>
          <p:nvPr/>
        </p:nvGrpSpPr>
        <p:grpSpPr>
          <a:xfrm>
            <a:off x="152280" y="838080"/>
            <a:ext cx="8839440" cy="5105520"/>
            <a:chOff x="152280" y="838080"/>
            <a:chExt cx="8839440" cy="5105520"/>
          </a:xfrm>
        </p:grpSpPr>
        <p:pic>
          <p:nvPicPr>
            <p:cNvPr id="399" name="" descr=""/>
            <p:cNvPicPr/>
            <p:nvPr/>
          </p:nvPicPr>
          <p:blipFill>
            <a:blip r:embed="rId1"/>
            <a:srcRect l="3510" t="8600" r="5263" b="1120"/>
            <a:stretch/>
          </p:blipFill>
          <p:spPr>
            <a:xfrm>
              <a:off x="152280" y="1143000"/>
              <a:ext cx="8839440" cy="4800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00" name=""/>
            <p:cNvSpPr/>
            <p:nvPr/>
          </p:nvSpPr>
          <p:spPr>
            <a:xfrm>
              <a:off x="229680" y="838080"/>
              <a:ext cx="1264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alcium signal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9" name=""/>
          <p:cNvGrpSpPr/>
          <p:nvPr/>
        </p:nvGrpSpPr>
        <p:grpSpPr>
          <a:xfrm>
            <a:off x="213840" y="135000"/>
            <a:ext cx="8625240" cy="6494400"/>
            <a:chOff x="213840" y="135000"/>
            <a:chExt cx="8625240" cy="6494400"/>
          </a:xfrm>
        </p:grpSpPr>
        <p:pic>
          <p:nvPicPr>
            <p:cNvPr id="90" name="" descr=""/>
            <p:cNvPicPr/>
            <p:nvPr/>
          </p:nvPicPr>
          <p:blipFill>
            <a:blip r:embed="rId1"/>
            <a:srcRect l="7339" t="10869" r="0" b="2188"/>
            <a:stretch/>
          </p:blipFill>
          <p:spPr>
            <a:xfrm>
              <a:off x="228600" y="457200"/>
              <a:ext cx="8610480" cy="617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"/>
            <p:cNvSpPr/>
            <p:nvPr/>
          </p:nvSpPr>
          <p:spPr>
            <a:xfrm>
              <a:off x="213840" y="135000"/>
              <a:ext cx="2442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atty-acid elongation in mitochondri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"/>
          <p:cNvSpPr/>
          <p:nvPr/>
        </p:nvSpPr>
        <p:spPr>
          <a:xfrm>
            <a:off x="7088040" y="6583320"/>
            <a:ext cx="20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4.1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02" name=""/>
          <p:cNvGrpSpPr/>
          <p:nvPr/>
        </p:nvGrpSpPr>
        <p:grpSpPr>
          <a:xfrm>
            <a:off x="152280" y="685800"/>
            <a:ext cx="8763120" cy="5410080"/>
            <a:chOff x="152280" y="685800"/>
            <a:chExt cx="8763120" cy="5410080"/>
          </a:xfrm>
        </p:grpSpPr>
        <p:pic>
          <p:nvPicPr>
            <p:cNvPr id="403" name="" descr=""/>
            <p:cNvPicPr/>
            <p:nvPr/>
          </p:nvPicPr>
          <p:blipFill>
            <a:blip r:embed="rId1"/>
            <a:srcRect l="8154" t="13448" r="0" b="2521"/>
            <a:stretch/>
          </p:blipFill>
          <p:spPr>
            <a:xfrm>
              <a:off x="152280" y="860400"/>
              <a:ext cx="8763120" cy="523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04" name=""/>
            <p:cNvSpPr/>
            <p:nvPr/>
          </p:nvSpPr>
          <p:spPr>
            <a:xfrm>
              <a:off x="152640" y="685800"/>
              <a:ext cx="3231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itric oxide signaling in the cardiovascular syste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3" name=""/>
          <p:cNvGrpSpPr/>
          <p:nvPr/>
        </p:nvGrpSpPr>
        <p:grpSpPr>
          <a:xfrm>
            <a:off x="213840" y="210960"/>
            <a:ext cx="8777880" cy="6418440"/>
            <a:chOff x="213840" y="210960"/>
            <a:chExt cx="8777880" cy="6418440"/>
          </a:xfrm>
        </p:grpSpPr>
        <p:pic>
          <p:nvPicPr>
            <p:cNvPr id="94" name="" descr=""/>
            <p:cNvPicPr/>
            <p:nvPr/>
          </p:nvPicPr>
          <p:blipFill>
            <a:blip r:embed="rId1"/>
            <a:srcRect l="5682" t="7316" r="0" b="1220"/>
            <a:stretch/>
          </p:blipFill>
          <p:spPr>
            <a:xfrm>
              <a:off x="304920" y="210960"/>
              <a:ext cx="8686800" cy="641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"/>
            <p:cNvSpPr/>
            <p:nvPr/>
          </p:nvSpPr>
          <p:spPr>
            <a:xfrm>
              <a:off x="213840" y="210960"/>
              <a:ext cx="1453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yruvate metabolis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"/>
          <p:cNvSpPr/>
          <p:nvPr/>
        </p:nvSpPr>
        <p:spPr>
          <a:xfrm>
            <a:off x="7088040" y="6583320"/>
            <a:ext cx="196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.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7" name=""/>
          <p:cNvGrpSpPr/>
          <p:nvPr/>
        </p:nvGrpSpPr>
        <p:grpSpPr>
          <a:xfrm>
            <a:off x="214200" y="135000"/>
            <a:ext cx="8701200" cy="6418080"/>
            <a:chOff x="214200" y="135000"/>
            <a:chExt cx="8701200" cy="6418080"/>
          </a:xfrm>
        </p:grpSpPr>
        <p:pic>
          <p:nvPicPr>
            <p:cNvPr id="98" name="" descr=""/>
            <p:cNvPicPr/>
            <p:nvPr/>
          </p:nvPicPr>
          <p:blipFill>
            <a:blip r:embed="rId1"/>
            <a:srcRect l="5619" t="6023" r="0" b="1205"/>
            <a:stretch/>
          </p:blipFill>
          <p:spPr>
            <a:xfrm>
              <a:off x="228600" y="336600"/>
              <a:ext cx="8686800" cy="6216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"/>
            <p:cNvSpPr/>
            <p:nvPr/>
          </p:nvSpPr>
          <p:spPr>
            <a:xfrm>
              <a:off x="214200" y="135000"/>
              <a:ext cx="204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rotein-ubiquitination pathwa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16:02:27Z</dcterms:created>
  <dc:creator>ZHAN</dc:creator>
  <dc:description/>
  <dc:language>en-US</dc:language>
  <cp:lastModifiedBy>XZHAN</cp:lastModifiedBy>
  <dcterms:modified xsi:type="dcterms:W3CDTF">2010-04-13T17:17:13Z</dcterms:modified>
  <cp:revision>138</cp:revision>
  <dc:subject/>
  <dc:title>PowerPoint Presentation</dc:title>
</cp:coreProperties>
</file>